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2" r:id="rId3"/>
    <p:sldId id="257" r:id="rId4"/>
    <p:sldId id="258" r:id="rId5"/>
    <p:sldId id="259" r:id="rId6"/>
    <p:sldId id="270" r:id="rId7"/>
    <p:sldId id="260" r:id="rId8"/>
    <p:sldId id="261" r:id="rId9"/>
    <p:sldId id="277" r:id="rId10"/>
    <p:sldId id="269" r:id="rId11"/>
    <p:sldId id="271" r:id="rId12"/>
    <p:sldId id="262" r:id="rId13"/>
    <p:sldId id="278" r:id="rId14"/>
    <p:sldId id="281" r:id="rId15"/>
    <p:sldId id="273" r:id="rId16"/>
    <p:sldId id="264" r:id="rId17"/>
    <p:sldId id="272" r:id="rId18"/>
    <p:sldId id="266" r:id="rId19"/>
    <p:sldId id="274" r:id="rId20"/>
    <p:sldId id="268" r:id="rId21"/>
    <p:sldId id="265" r:id="rId22"/>
    <p:sldId id="275" r:id="rId2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16176"/>
    <a:srgbClr val="008080"/>
    <a:srgbClr val="663300"/>
    <a:srgbClr val="4472C4"/>
    <a:srgbClr val="FF3B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90" y="58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142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413210-EBC8-465D-8B0A-1C2E0D3490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AB4A19-FD07-4759-9394-0D7613846B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0C8677-A6CC-4320-8BB2-F8AF0C1BB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36FA9C-0665-4925-9E47-2C94C8D30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3516C5-8532-4E48-B4A5-102F6B7D4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671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5C0C5D-B0F1-4226-AC0F-6CA4F2F49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D1B798-C729-485E-B879-9B16879452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0CDE2B-83F2-4490-8AC3-1FC84E8084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EF59B7-C8C2-4ED9-B100-85AEB477B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78CF85-9ACB-420A-A82C-AA71F31C4D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852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A9DA68-EDD3-4AD6-AAB9-948C7708D0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827C6E-38D1-4AF7-BBD5-83355C50C9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9F0649-8727-44E0-B8C6-6B955A5D9E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BB61A-4816-49D0-B468-BF16352E7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3560C6-66A6-4330-B538-DF291B1D9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466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4B4EE-99B0-4CCE-8950-462EA6B1F5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16C740-9DF5-4D3F-A55D-0946D3F17F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79E2DE-0B3A-41E4-BF2F-A651EC3821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4BF9FE-0671-4BFC-A164-FBDAB100DC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B11777-0A5A-4C95-A182-BA9B2F335E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663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965F8B-ADAD-46B7-A4E4-A119401E55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44D1A0-7B1D-46B8-A208-4AE012234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D2673D-CDBF-47FE-A61E-9934AE467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DB8BB8-6ECE-4964-A55B-217B71A44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F33C3F-7EFC-4592-8A85-BB062C13BE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844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8E348B-414A-479A-BBBA-70626EB3E3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6EB1B-411F-4DB9-8930-4DFE4E55EE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173D1B-3B19-4FF9-94E6-6451430A13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8C6077-F1DC-47F8-9AB1-3E08388DF7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E131D5-D7A9-471C-AB45-1B301EEAF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B225C1-5B59-404A-9E36-20605713B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355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5CD522-2919-441D-832E-06D06F3011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8B0962-74E8-4629-A0A3-F446DDD158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2C3AB5-4081-4DB3-ABFD-BD0EAC7BA3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03F331-9701-4884-9E4E-7D21DC9D38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B3170D-9732-4BD2-A6E7-C990D3E0C2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4CB3C2-3B31-4E4A-AEFB-6599BEFB0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5A6FEDA-B377-49CF-A611-484EBFF57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DE886E-0A61-4FE6-B92E-FD6F6F187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239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802B6-532B-46FB-846B-5BA4E892A4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7C46D94-860A-47D0-A77C-688752769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B61245E-D58E-476B-BD7E-57009D7A0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6E174C5-CA74-4DF9-811B-1F10DB92A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394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EDD64D-9EA9-4598-9E89-659BC94E0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F0F6ED8-73A8-4B23-AF5F-BCBF70BD9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F982758-EF45-4880-8B4C-76865CAD5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5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71533F-C7ED-4522-A07E-6569B4F54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881250-CCDB-4E68-AF18-67196053C7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39A754-F6EE-47D7-8415-7ABDB2CC85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F5582F-B7E8-4061-B60D-180E2A38E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49F256-FDE5-4B4D-973A-1D766FB2C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303C6E-1CDA-4040-A0D0-236E9CBE8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8036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D7253-8919-41D9-B29E-67E01FE586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2FC738-D2FB-4C1B-B6FB-029119732A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77DEF0-AE7C-471E-B221-10A3F4C270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303BBB-E3A4-446E-B575-87C6BD2D9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7335DD-61E2-47F2-B4F9-C8A5BCD02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833972-903C-4DD6-A9CF-75CCE4F3B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383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4E8629-AD0F-4A33-BFF7-F115CB031E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6ED253-3576-4033-B806-3931E5BE31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FCE44C-E3BB-44A3-A496-6C3D45565D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6EEEF-5A0D-4C69-9137-DC487DE30C7F}" type="datetimeFigureOut">
              <a:rPr lang="en-US" smtClean="0"/>
              <a:t>1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62624-98EA-4629-B3E8-F856FBD576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2159C-36EE-4853-AA81-383F577E85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CF60A-F706-478B-A4A7-AF939F1FDB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842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hyperlink" Target="https://www.reuters.com/article/us-health-coronavirus-netherlands/netherlands-to-go-into-tough-five-week-lockdown-over-christmas-idUSKBN28O168" TargetMode="External"/><Relationship Id="rId7" Type="http://schemas.openxmlformats.org/officeDocument/2006/relationships/image" Target="../media/image2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en.wikipedia.org/wiki/COVID-19_pandemic_in_the_Netherlands" TargetMode="External"/><Relationship Id="rId5" Type="http://schemas.openxmlformats.org/officeDocument/2006/relationships/hyperlink" Target="https://www.expatica.com/nl/education/children-education/school-holidays-in-the-netherlands-70515/" TargetMode="External"/><Relationship Id="rId4" Type="http://schemas.openxmlformats.org/officeDocument/2006/relationships/hyperlink" Target="https://whtc.com/2020/09/01/back-to-school-how-european-classrooms-are-coping-with-covid/1054001/" TargetMode="Externa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bloomberg.com/news/articles/2020-12-06/denmark-plans-partial-lockdown-of-main-cities-after-record-cases" TargetMode="External"/><Relationship Id="rId7" Type="http://schemas.openxmlformats.org/officeDocument/2006/relationships/image" Target="../media/image3.png"/><Relationship Id="rId2" Type="http://schemas.openxmlformats.org/officeDocument/2006/relationships/hyperlink" Target="https://www.reuters.com/article/us-health-coronavirus-denmark-reopening/reopening-schools-in-denmark-did-not-worsen-outbreak-data-shows-idUSKBN2341N7https:/www.ft.com/content/daf20d07-738f-4640-8a4a-d6de3e1e4c37" TargetMode="Externa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2.png"/><Relationship Id="rId4" Type="http://schemas.openxmlformats.org/officeDocument/2006/relationships/image" Target="../media/image1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aa.com.tr/en/europe/spain-s-big-back-to-school-experiment/1969928" TargetMode="External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s://en.wikipedia.org/wiki/COVID-19_pandemic_in_Spain" TargetMode="Externa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irishtimes.com/news/politics/covid-19-cabinet-agrees-to-keep-schools-closed-for-january-in-most-challenging-phase-of-all-1.4451482" TargetMode="External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hyperlink" Target="https://www.expatica.com/pt/education/children-education/school-holidays-in-portugal-69027/" TargetMode="External"/><Relationship Id="rId7" Type="http://schemas.openxmlformats.org/officeDocument/2006/relationships/hyperlink" Target="https://www.reuters.com/article/health-coronavirus-portugal/update-1-new-covid-19-lockdown-to-come-into-force-in-portugal-from-friday-idUSL1N2JO2H2" TargetMode="External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garda.com/crisis24/news-alerts/395261/portugal-authorities-impose-partial-lockdown-in-several-regions-november-4-update-27" TargetMode="External"/><Relationship Id="rId5" Type="http://schemas.openxmlformats.org/officeDocument/2006/relationships/hyperlink" Target="https://www.usnews.com/news/world/articles/2020-08-27/stricter-virus-measures-loom-as-students-return-to-portugals-schools" TargetMode="External"/><Relationship Id="rId4" Type="http://schemas.openxmlformats.org/officeDocument/2006/relationships/hyperlink" Target="https://www.reuters.com/article/us-health-coronavirus-portugal/portugal-relaxes-coronavirus-lockdown-with-sector-by-sector-plan-idUSKBN22C36R" TargetMode="External"/><Relationship Id="rId9" Type="http://schemas.openxmlformats.org/officeDocument/2006/relationships/image" Target="../media/image3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reuters.com/article/healthcoronavirus-belgium/belgian-schools-to-reopen-in-september-masks-mandatory-for-older-children-idUSL8N2FM3RK" TargetMode="External"/><Relationship Id="rId7" Type="http://schemas.openxmlformats.org/officeDocument/2006/relationships/image" Target="../media/image3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hyperlink" Target="https://en.wikipedia.org/wiki/COVID-19_pandemic_in_Belgium" TargetMode="External"/><Relationship Id="rId4" Type="http://schemas.openxmlformats.org/officeDocument/2006/relationships/hyperlink" Target="https://www.politico.eu/article/belgium-announces-second-coronavirus-lockdown/" TargetMode="Externa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edarabia.com/school-holidays-italy/" TargetMode="External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s://www.aa.com.tr/en/education/students-parents-fight-school-closures-in-italy/2069281" TargetMode="External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hyperlink" Target="https://www.usnews.com/news/world/articles/2020-10-12/czech-government-closing-bars-shifting-schools-to-distance-learning-amid-covid-19-surge" TargetMode="External"/><Relationship Id="rId7" Type="http://schemas.openxmlformats.org/officeDocument/2006/relationships/image" Target="../media/image2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avoid-crowds.com/2021-czech-republic-school-vacations-public-holidays/" TargetMode="External"/><Relationship Id="rId5" Type="http://schemas.openxmlformats.org/officeDocument/2006/relationships/hyperlink" Target="https://www.irishtimes.com/news/world/europe/czechs-reverse-relaxation-of-covid-19-restrictions-to-avert-christmas-surge-1.4437636" TargetMode="External"/><Relationship Id="rId4" Type="http://schemas.openxmlformats.org/officeDocument/2006/relationships/hyperlink" Target="https://www.studyinternational.com/news/reopen-elementary-schools-czechs/" TargetMode="Externa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hyperlink" Target="https://www.cbsnews.com/news/japan-schools-back-in-session-coronavirus-pandemic-covid-19/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hyperlink" Target="https://www.wsj.com/articles/remote-learning-in-south-korea-becomes-a-fixture-of-pandemic-life-11599668494" TargetMode="External"/><Relationship Id="rId7" Type="http://schemas.openxmlformats.org/officeDocument/2006/relationships/image" Target="../media/image2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koreatimes.co.kr/www/nation/2020/09/181_296397.html" TargetMode="External"/><Relationship Id="rId5" Type="http://schemas.openxmlformats.org/officeDocument/2006/relationships/hyperlink" Target="https://www.bbc.com/news/world-asia-53901707" TargetMode="External"/><Relationship Id="rId4" Type="http://schemas.openxmlformats.org/officeDocument/2006/relationships/hyperlink" Target="https://www.reuters.com/article/health-coronavirus-southkorea/south-korea-orders-schools-to-shut-as-covid-19-cases-spike-idUSKBN28O09O" TargetMode="Externa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theglobeandmail.com/canada/article-ontario-to-close-all-public-schools-for-two-weeks-after-march-break/" TargetMode="External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s://www.reuters.com/article/us-health-coronavirus-canada-education/coronavirus-angst-as-canadian-schools-start-to-open-idUSKBN25U1N4" TargetMode="Externa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hyperlink" Target="https://tn.chalkbeat.org/2020/7/31/21349881/one-of-americas-first-states-to-reopen-schools-in-person-tennessee-serves-as-covid-experiment" TargetMode="Externa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hyperlink" Target="https://www.npr.org/sections/coronavirus-live-updates/2020/06/03/868507524/israel-orders-schools-to-close-when-covid-19-cases-are-discovered" TargetMode="External"/><Relationship Id="rId7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://www.xinhuanet.com/english/2020-09/13/c_139363901.htm" TargetMode="External"/><Relationship Id="rId5" Type="http://schemas.openxmlformats.org/officeDocument/2006/relationships/hyperlink" Target="https://www.wsj.com/articles/israelis-fear-schools-reopened-too-soon-as-covid-19-cases-climb-11594760001" TargetMode="External"/><Relationship Id="rId4" Type="http://schemas.openxmlformats.org/officeDocument/2006/relationships/hyperlink" Target="https://www.timesofisrael.com/school-is-back-in-session-for-grades-1-4-as-lockdown-eased-synagogues-reopen/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dawn.com/news/1555102" TargetMode="Externa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hyperlink" Target="https://www.dawn.com/news/1591943" TargetMode="External"/><Relationship Id="rId4" Type="http://schemas.openxmlformats.org/officeDocument/2006/relationships/hyperlink" Target="https://www.dawn.com/news/1578399" TargetMode="Externa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en.wikipedia.org/wiki/COVID-19_pandemic_in_India" TargetMode="External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s://www.livemint.com/news/world/closing-down-schools-again-will-harm-320mn-students-worldwide-says-unicef-11607404867611.html" TargetMode="Externa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hyperlink" Target="https://www.voanews.com/covid-19-pandemic/sweden-closes-high-schools-until-early-january-stem-covid-19-infections" TargetMode="Externa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hyperlink" Target="https://www.bbc.com/news/world-europe-54716993" TargetMode="External"/><Relationship Id="rId7" Type="http://schemas.openxmlformats.org/officeDocument/2006/relationships/image" Target="../media/image7.png"/><Relationship Id="rId2" Type="http://schemas.openxmlformats.org/officeDocument/2006/relationships/hyperlink" Target="https://www.nbcnews.com/health/health-news/70-cases-covid-19-french-schools-days-after-re-opening-n1209591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wsj.com/articles/as-covid-19-surges-the-big-unknown-is-where-people-are-getting-infected-11605474874" TargetMode="External"/><Relationship Id="rId5" Type="http://schemas.openxmlformats.org/officeDocument/2006/relationships/hyperlink" Target="https://www.wsj.com/articles/contact-tracing-the-wests-big-hope-for-suppressing-covid-19-is-in-disarray-11600337670?mod=article_inline" TargetMode="External"/><Relationship Id="rId10" Type="http://schemas.openxmlformats.org/officeDocument/2006/relationships/image" Target="../media/image3.png"/><Relationship Id="rId4" Type="http://schemas.openxmlformats.org/officeDocument/2006/relationships/hyperlink" Target="https://www.thelocal.fr/20210104/analysis-is-france-right-to-keep-its-schools-open-during-pandemic" TargetMode="External"/><Relationship Id="rId9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hyperlink" Target="https://fortune.com/2020/08/10/covid-schools-reopening-class-children-coronavirus/" TargetMode="External"/><Relationship Id="rId7" Type="http://schemas.openxmlformats.org/officeDocument/2006/relationships/image" Target="../media/image2.png"/><Relationship Id="rId2" Type="http://schemas.openxmlformats.org/officeDocument/2006/relationships/hyperlink" Target="https://en.wikipedia.org/wiki/COVID-19_pandemic_in_Germany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wsj.com/articles/as-covid-19-surges-the-big-unknown-is-where-people-are-getting-infected-11605474874" TargetMode="External"/><Relationship Id="rId5" Type="http://schemas.openxmlformats.org/officeDocument/2006/relationships/hyperlink" Target="https://www.wsj.com/articles/contact-tracing-the-wests-big-hope-for-suppressing-covid-19-is-in-disarray-11600337670?mod=article_inline" TargetMode="External"/><Relationship Id="rId10" Type="http://schemas.openxmlformats.org/officeDocument/2006/relationships/image" Target="../media/image3.png"/><Relationship Id="rId4" Type="http://schemas.openxmlformats.org/officeDocument/2006/relationships/hyperlink" Target="https://www.theguardian.com/world/2020/dec/13/germany-to-close-shops-and-schools-in-tightened-covid-lockdown" TargetMode="External"/><Relationship Id="rId9" Type="http://schemas.openxmlformats.org/officeDocument/2006/relationships/image" Target="../media/image1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cidrap.umn.edu/news-perspective/2020/12/few-cases-or-outbreaks-uk-schools-reopened-after-lockdown" TargetMode="External"/><Relationship Id="rId7" Type="http://schemas.openxmlformats.org/officeDocument/2006/relationships/image" Target="../media/image3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hyperlink" Target="https://www.telegraph.co.uk/news/2021/01/11/schools-closed-new-lockdown-when-reopen-uk-areas-covid/" TargetMode="External"/><Relationship Id="rId4" Type="http://schemas.openxmlformats.org/officeDocument/2006/relationships/hyperlink" Target="https://www.nytimes.com/2020/08/29/world/europe/britain-schools-reopen-cornavirus.html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2B5774-C270-445E-BD13-2D9C5994C913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Timing of school opening and closing vs COVID case counts</a:t>
            </a:r>
          </a:p>
        </p:txBody>
      </p:sp>
    </p:spTree>
    <p:extLst>
      <p:ext uri="{BB962C8B-B14F-4D97-AF65-F5344CB8AC3E}">
        <p14:creationId xmlns:p14="http://schemas.microsoft.com/office/powerpoint/2010/main" val="38716801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839AD40-E759-4476-9A3B-DD20C7BE63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08973" y="960928"/>
            <a:ext cx="7298627" cy="4004501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Netherland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569939" cy="1354545"/>
          </a:xfrm>
        </p:spPr>
        <p:txBody>
          <a:bodyPr>
            <a:normAutofit fontScale="77500" lnSpcReduction="20000"/>
          </a:bodyPr>
          <a:lstStyle/>
          <a:p>
            <a:r>
              <a:rPr lang="en-US" sz="1600" dirty="0"/>
              <a:t>School closing: 3/15</a:t>
            </a:r>
          </a:p>
          <a:p>
            <a:r>
              <a:rPr lang="en-US" sz="1600" dirty="0"/>
              <a:t>School reopening: ~8/5 (in stages)</a:t>
            </a:r>
          </a:p>
          <a:p>
            <a:r>
              <a:rPr lang="en-US" sz="1600" dirty="0"/>
              <a:t>School closing (autumn break): 10/10-10/19</a:t>
            </a:r>
          </a:p>
          <a:p>
            <a:r>
              <a:rPr lang="en-US" sz="1600" dirty="0"/>
              <a:t>School closing: 12/13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8524875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reuters.com/article/us-health-coronavirus-netherlands/netherlands-to-go-into-tough-five-week-lockdown-over-christmas-idUSKBN28O168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htc.com/2020/09/01/back-to-school-how-european-classrooms-are-coping-with-covid/1054001/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5"/>
              </a:rPr>
              <a:t>https://www.expatica.com/nl/education/children-education/school-holidays-in-the-netherlands-70515/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6"/>
              </a:rPr>
              <a:t>https://en.wikipedia.org/wiki/COVID-19_pandemic_in_the_Netherlands</a:t>
            </a:r>
            <a:r>
              <a:rPr lang="en-US" sz="900" dirty="0"/>
              <a:t> </a:t>
            </a:r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6549364" y="4155769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9153524" y="2045780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6C3120-3238-4260-8908-0CE6FE62F4F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6DF51523-B666-4E06-96D8-036F89B0992A}"/>
              </a:ext>
            </a:extLst>
          </p:cNvPr>
          <p:cNvSpPr/>
          <p:nvPr/>
        </p:nvSpPr>
        <p:spPr>
          <a:xfrm rot="5400000">
            <a:off x="7896224" y="2751629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id="{4ECEEEBA-7E3B-4F4F-A438-09AD8F383EEF}"/>
              </a:ext>
            </a:extLst>
          </p:cNvPr>
          <p:cNvSpPr/>
          <p:nvPr/>
        </p:nvSpPr>
        <p:spPr>
          <a:xfrm rot="5400000">
            <a:off x="8096249" y="1843565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614B88CA-0945-431B-8BBF-4E648A50E81C}"/>
              </a:ext>
            </a:extLst>
          </p:cNvPr>
          <p:cNvSpPr/>
          <p:nvPr/>
        </p:nvSpPr>
        <p:spPr>
          <a:xfrm rot="5400000">
            <a:off x="3762374" y="4207525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A14A3A-D006-448A-BFAB-E503572C55BC}"/>
              </a:ext>
            </a:extLst>
          </p:cNvPr>
          <p:cNvSpPr txBox="1"/>
          <p:nvPr/>
        </p:nvSpPr>
        <p:spPr>
          <a:xfrm>
            <a:off x="2689927" y="265294"/>
            <a:ext cx="5919441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in August, followed by a wave of infections.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Recent months have seen oscillations in case counts (with two periods of school closure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357BF925-A94D-4E5A-A5AA-CEA5BBCCC29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77270061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Denmark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627697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2"/>
              </a:rPr>
              <a:t>https://www.reuters.com/article/us-health-coronavirus-denmark-reopening/reopening-schools-in-denmark-did-not-worsen-outbreak-data-shows-idUSKBN2341N7</a:t>
            </a:r>
          </a:p>
          <a:p>
            <a:r>
              <a:rPr lang="en-US" sz="900" dirty="0">
                <a:hlinkClick r:id="rId2"/>
              </a:rPr>
              <a:t>https://www.ft.com/content/daf20d07-738f-4640-8a4a-d6de3e1e4c37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3"/>
              </a:rPr>
              <a:t>https://www.bloomberg.com/news/articles/2020-12-06/denmark-plans-partial-lockdown-of-main-cities-after-record-cases</a:t>
            </a:r>
            <a:r>
              <a:rPr lang="en-US" sz="900" dirty="0"/>
              <a:t> </a:t>
            </a:r>
          </a:p>
        </p:txBody>
      </p:sp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90D604D9-6733-4C29-B5C4-A6FB3BE012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3003326" cy="1354545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~3/15</a:t>
            </a:r>
          </a:p>
          <a:p>
            <a:r>
              <a:rPr lang="en-US" sz="1600" dirty="0"/>
              <a:t>School reopening: 4/15 (primary schools only)</a:t>
            </a:r>
          </a:p>
          <a:p>
            <a:r>
              <a:rPr lang="en-US" sz="1600" dirty="0"/>
              <a:t>School reopening: 5/18 (secondary schools)</a:t>
            </a:r>
          </a:p>
          <a:p>
            <a:r>
              <a:rPr lang="en-US" sz="1600" dirty="0"/>
              <a:t>School closing: 6/28 (summer break)</a:t>
            </a:r>
          </a:p>
          <a:p>
            <a:r>
              <a:rPr lang="en-US" sz="1600" dirty="0"/>
              <a:t>School reopening: 8/1 </a:t>
            </a:r>
          </a:p>
          <a:p>
            <a:r>
              <a:rPr lang="en-US" sz="1600" dirty="0"/>
              <a:t>School closing: 12/6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BFC309EB-980C-4188-9F84-B2F217E06E50}"/>
              </a:ext>
            </a:extLst>
          </p:cNvPr>
          <p:cNvGrpSpPr/>
          <p:nvPr/>
        </p:nvGrpSpPr>
        <p:grpSpPr>
          <a:xfrm>
            <a:off x="3332656" y="957262"/>
            <a:ext cx="7374944" cy="4473730"/>
            <a:chOff x="3332656" y="957262"/>
            <a:chExt cx="7374944" cy="4473730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331F959C-7230-4BB1-AE11-5265BB6E460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08973" y="960928"/>
              <a:ext cx="7298627" cy="4004501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96C3120-3238-4260-8908-0CE6FE62F4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93104"/>
            <a:stretch/>
          </p:blipFill>
          <p:spPr>
            <a:xfrm>
              <a:off x="3332656" y="5110826"/>
              <a:ext cx="7374944" cy="320166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A5165085-DEAD-48FC-B02B-56F38E65ECA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18381" y="957262"/>
              <a:ext cx="7028307" cy="3916490"/>
            </a:xfrm>
            <a:prstGeom prst="rect">
              <a:avLst/>
            </a:prstGeom>
          </p:spPr>
        </p:pic>
        <p:sp>
          <p:nvSpPr>
            <p:cNvPr id="13" name="Arrow: Right 12">
              <a:extLst>
                <a:ext uri="{FF2B5EF4-FFF2-40B4-BE49-F238E27FC236}">
                  <a16:creationId xmlns:a16="http://schemas.microsoft.com/office/drawing/2014/main" id="{1031C9CC-505B-413F-A285-A2FDD3C4AE30}"/>
                </a:ext>
              </a:extLst>
            </p:cNvPr>
            <p:cNvSpPr/>
            <p:nvPr/>
          </p:nvSpPr>
          <p:spPr>
            <a:xfrm rot="5400000">
              <a:off x="4527199" y="4116236"/>
              <a:ext cx="457200" cy="180975"/>
            </a:xfrm>
            <a:prstGeom prst="rightArrow">
              <a:avLst/>
            </a:prstGeom>
            <a:solidFill>
              <a:srgbClr val="4472C4">
                <a:alpha val="40000"/>
              </a:srgbClr>
            </a:solidFill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Arrow: Right 13">
              <a:extLst>
                <a:ext uri="{FF2B5EF4-FFF2-40B4-BE49-F238E27FC236}">
                  <a16:creationId xmlns:a16="http://schemas.microsoft.com/office/drawing/2014/main" id="{030A166B-D4B8-4B1A-94B7-A0EA250CB74F}"/>
                </a:ext>
              </a:extLst>
            </p:cNvPr>
            <p:cNvSpPr/>
            <p:nvPr/>
          </p:nvSpPr>
          <p:spPr>
            <a:xfrm rot="5400000">
              <a:off x="3752848" y="4131420"/>
              <a:ext cx="457200" cy="180975"/>
            </a:xfrm>
            <a:prstGeom prst="rightArrow">
              <a:avLst/>
            </a:prstGeom>
            <a:solidFill>
              <a:srgbClr val="FF3B3B">
                <a:alpha val="40000"/>
              </a:srgbClr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5" name="Arrow: Right 14">
              <a:extLst>
                <a:ext uri="{FF2B5EF4-FFF2-40B4-BE49-F238E27FC236}">
                  <a16:creationId xmlns:a16="http://schemas.microsoft.com/office/drawing/2014/main" id="{75DE9AE9-35A9-464C-9804-AE8D944054DC}"/>
                </a:ext>
              </a:extLst>
            </p:cNvPr>
            <p:cNvSpPr/>
            <p:nvPr/>
          </p:nvSpPr>
          <p:spPr>
            <a:xfrm rot="5400000">
              <a:off x="5080740" y="4198096"/>
              <a:ext cx="457200" cy="180975"/>
            </a:xfrm>
            <a:prstGeom prst="rightArrow">
              <a:avLst/>
            </a:prstGeom>
            <a:solidFill>
              <a:srgbClr val="4472C4">
                <a:alpha val="40000"/>
              </a:srgbClr>
            </a:solidFill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Arrow: Right 15">
              <a:extLst>
                <a:ext uri="{FF2B5EF4-FFF2-40B4-BE49-F238E27FC236}">
                  <a16:creationId xmlns:a16="http://schemas.microsoft.com/office/drawing/2014/main" id="{13A587AB-4FBE-42F6-8F36-63D1E77DC15E}"/>
                </a:ext>
              </a:extLst>
            </p:cNvPr>
            <p:cNvSpPr/>
            <p:nvPr/>
          </p:nvSpPr>
          <p:spPr>
            <a:xfrm rot="5400000">
              <a:off x="5895973" y="4245722"/>
              <a:ext cx="457200" cy="180975"/>
            </a:xfrm>
            <a:prstGeom prst="rightArrow">
              <a:avLst/>
            </a:prstGeom>
            <a:solidFill>
              <a:srgbClr val="FF3B3B">
                <a:alpha val="40000"/>
              </a:srgbClr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" name="Arrow: Right 16">
              <a:extLst>
                <a:ext uri="{FF2B5EF4-FFF2-40B4-BE49-F238E27FC236}">
                  <a16:creationId xmlns:a16="http://schemas.microsoft.com/office/drawing/2014/main" id="{00CDBCE0-0393-439A-90CA-EF80A2D0F667}"/>
                </a:ext>
              </a:extLst>
            </p:cNvPr>
            <p:cNvSpPr/>
            <p:nvPr/>
          </p:nvSpPr>
          <p:spPr>
            <a:xfrm rot="5400000">
              <a:off x="6586277" y="4236364"/>
              <a:ext cx="457200" cy="180975"/>
            </a:xfrm>
            <a:prstGeom prst="rightArrow">
              <a:avLst/>
            </a:prstGeom>
            <a:solidFill>
              <a:srgbClr val="4472C4">
                <a:alpha val="40000"/>
              </a:srgbClr>
            </a:solidFill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Arrow: Right 17">
              <a:extLst>
                <a:ext uri="{FF2B5EF4-FFF2-40B4-BE49-F238E27FC236}">
                  <a16:creationId xmlns:a16="http://schemas.microsoft.com/office/drawing/2014/main" id="{AA5B34DD-47C9-4301-B31A-34D452792601}"/>
                </a:ext>
              </a:extLst>
            </p:cNvPr>
            <p:cNvSpPr/>
            <p:nvPr/>
          </p:nvSpPr>
          <p:spPr>
            <a:xfrm rot="5400000">
              <a:off x="9210675" y="2397871"/>
              <a:ext cx="457200" cy="180975"/>
            </a:xfrm>
            <a:prstGeom prst="rightArrow">
              <a:avLst/>
            </a:prstGeom>
            <a:solidFill>
              <a:srgbClr val="FF3B3B">
                <a:alpha val="40000"/>
              </a:srgbClr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8D79A92E-DC19-47D5-AEC1-B081EB0EB7C6}"/>
              </a:ext>
            </a:extLst>
          </p:cNvPr>
          <p:cNvSpPr txBox="1"/>
          <p:nvPr/>
        </p:nvSpPr>
        <p:spPr>
          <a:xfrm>
            <a:off x="2689927" y="265294"/>
            <a:ext cx="4924425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opened and closed intermittently in the spring and early summer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Classes were conducted mostly outdoors in the summer 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Full return to school in early August, followed by a steady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again in December, followed by a drop in cases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D229F11C-0332-4AD2-BB52-1D232C34F25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10310629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AD10CDE-E7AA-4773-A2B6-90D7CD5F19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03937" y="1643062"/>
            <a:ext cx="7166610" cy="3891344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" y="31327"/>
            <a:ext cx="1943100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Spai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1354545"/>
          </a:xfrm>
        </p:spPr>
        <p:txBody>
          <a:bodyPr>
            <a:normAutofit/>
          </a:bodyPr>
          <a:lstStyle/>
          <a:p>
            <a:r>
              <a:rPr lang="en-US" sz="1600" dirty="0"/>
              <a:t>School closing: 3/12</a:t>
            </a:r>
          </a:p>
          <a:p>
            <a:r>
              <a:rPr lang="en-US" sz="1600" dirty="0"/>
              <a:t>School reopening: 9/9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704850" y="6216540"/>
            <a:ext cx="481965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aa.com.tr/en/europe/spain-s-big-back-to-school-experiment/1969928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en.wikipedia.org/wiki/COVID-19_pandemic_in_Spain</a:t>
            </a:r>
            <a:r>
              <a:rPr lang="en-US" sz="900" dirty="0"/>
              <a:t> </a:t>
            </a:r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7501864" y="3441098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3803972" y="4791245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916EA98-C775-42BF-818A-6947299B002E}"/>
              </a:ext>
            </a:extLst>
          </p:cNvPr>
          <p:cNvSpPr txBox="1"/>
          <p:nvPr/>
        </p:nvSpPr>
        <p:spPr>
          <a:xfrm>
            <a:off x="2689927" y="265294"/>
            <a:ext cx="6029599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arch, and were reopened in early September during a rise in case cou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Cases continued to rise after school reopening, and remain high as of Januar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41% of cases from May-October were of unknown origin (Wikipedia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D45F76E-05C7-43B7-AC55-ED99696703E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66882421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C6A66D1-83EB-458F-B3EB-43C73BE896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4086" y="1374838"/>
            <a:ext cx="7310628" cy="410832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" y="31327"/>
            <a:ext cx="1943100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Irela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2045601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3/12</a:t>
            </a:r>
          </a:p>
          <a:p>
            <a:r>
              <a:rPr lang="en-US" sz="1600" dirty="0"/>
              <a:t>School reopening: ~9/1</a:t>
            </a:r>
          </a:p>
          <a:p>
            <a:r>
              <a:rPr lang="en-US" sz="1600" dirty="0"/>
              <a:t>School closing: 10/15 (October break)</a:t>
            </a:r>
          </a:p>
          <a:p>
            <a:r>
              <a:rPr lang="en-US" sz="1600" dirty="0"/>
              <a:t>School reopening: 10/22</a:t>
            </a:r>
          </a:p>
          <a:p>
            <a:r>
              <a:rPr lang="en-US" sz="1600" dirty="0"/>
              <a:t>School closing: 12/22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704850" y="6216540"/>
            <a:ext cx="769837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clareecho.ie/no-homework-for-september-at-least-as-schools-reopen/</a:t>
            </a:r>
          </a:p>
          <a:p>
            <a:r>
              <a:rPr lang="en-US" sz="900" dirty="0">
                <a:hlinkClick r:id="rId3"/>
              </a:rPr>
              <a:t>https://www.irishtimes.com/news/education/it-is-not-going-to-be-extended-donnelly-says-midterm-break-won-t-be-longer-than-a-week-1.4377888</a:t>
            </a:r>
          </a:p>
          <a:p>
            <a:r>
              <a:rPr lang="en-US" sz="900" dirty="0">
                <a:hlinkClick r:id="rId3"/>
              </a:rPr>
              <a:t>https://www.irishtimes.com/news/politics/covid-19-cabinet-agrees-to-keep-schools-closed-for-january-in-most-challenging-phase-of-all-1.4451482</a:t>
            </a:r>
            <a:endParaRPr lang="en-US" sz="900" dirty="0"/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7309585" y="4643031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9446391" y="4379705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916EA98-C775-42BF-818A-6947299B002E}"/>
              </a:ext>
            </a:extLst>
          </p:cNvPr>
          <p:cNvSpPr txBox="1"/>
          <p:nvPr/>
        </p:nvSpPr>
        <p:spPr>
          <a:xfrm>
            <a:off x="2689927" y="265294"/>
            <a:ext cx="6271269" cy="10156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arch, and were reopened in early September followed rise in case cou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The country was put under partial lockdown in mid-October (schools in theory remained open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for a week at this time, and then reopened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have remained closed since December 22</a:t>
            </a:r>
            <a:r>
              <a:rPr lang="en-US" sz="1200" baseline="30000" dirty="0"/>
              <a:t>nd</a:t>
            </a:r>
            <a:r>
              <a:rPr lang="en-US" sz="1200" dirty="0"/>
              <a:t>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Ireland experienced its largest spike in cases yet at the end of December</a:t>
            </a:r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853A1486-791E-49C7-8509-96469700EB5A}"/>
              </a:ext>
            </a:extLst>
          </p:cNvPr>
          <p:cNvSpPr/>
          <p:nvPr/>
        </p:nvSpPr>
        <p:spPr>
          <a:xfrm rot="5400000">
            <a:off x="8115270" y="4195562"/>
            <a:ext cx="457200" cy="180975"/>
          </a:xfrm>
          <a:prstGeom prst="rightArrow">
            <a:avLst/>
          </a:prstGeom>
          <a:solidFill>
            <a:schemeClr val="bg1">
              <a:lumMod val="65000"/>
              <a:alpha val="40000"/>
            </a:schemeClr>
          </a:solidFill>
          <a:ln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88066261-B67E-4D6A-8DEF-FBBFF656F823}"/>
              </a:ext>
            </a:extLst>
          </p:cNvPr>
          <p:cNvSpPr/>
          <p:nvPr/>
        </p:nvSpPr>
        <p:spPr>
          <a:xfrm rot="5400000">
            <a:off x="3982568" y="4652763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8EFE9DA8-219F-453F-A48F-3BB81F264234}"/>
              </a:ext>
            </a:extLst>
          </p:cNvPr>
          <p:cNvSpPr/>
          <p:nvPr/>
        </p:nvSpPr>
        <p:spPr>
          <a:xfrm rot="5400000">
            <a:off x="8287500" y="4124975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D70F5D25-6B7C-4FED-BAC1-2691C77B114D}"/>
              </a:ext>
            </a:extLst>
          </p:cNvPr>
          <p:cNvSpPr/>
          <p:nvPr/>
        </p:nvSpPr>
        <p:spPr>
          <a:xfrm rot="5400000">
            <a:off x="8468475" y="4336855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76216E72-90F7-4145-8815-7C4AE5C498E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74986529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2E87887A-F7FB-42E0-9AF1-E7572F9D7C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0936" y="1056166"/>
            <a:ext cx="7349681" cy="440512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" y="31327"/>
            <a:ext cx="1943100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Portuga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1354545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3/15</a:t>
            </a:r>
          </a:p>
          <a:p>
            <a:r>
              <a:rPr lang="en-US" sz="1600" dirty="0"/>
              <a:t>School reopening: 5/18 (limited)</a:t>
            </a:r>
          </a:p>
          <a:p>
            <a:r>
              <a:rPr lang="en-US" sz="1600" dirty="0"/>
              <a:t>Schools closing: ~6/9 (summer)</a:t>
            </a:r>
          </a:p>
          <a:p>
            <a:r>
              <a:rPr lang="en-US" sz="1600" dirty="0"/>
              <a:t>School reopening: 9/1</a:t>
            </a:r>
          </a:p>
          <a:p>
            <a:endParaRPr lang="en-US" sz="16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704850" y="6054490"/>
            <a:ext cx="8014676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expatica.com/pt/education/children-education/school-holidays-in-portugal-69027/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reuters.com/article/us-health-coronavirus-portugal/portugal-relaxes-coronavirus-lockdown-with-sector-by-sector-plan-idUSKBN22C36R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5"/>
              </a:rPr>
              <a:t>https://www.usnews.com/news/world/articles/2020-08-27/stricter-virus-measures-loom-as-students-return-to-portugals-schools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6"/>
              </a:rPr>
              <a:t>https://www.garda.com/crisis24/news-alerts/395261/portugal-authorities-impose-partial-lockdown-in-several-regions-november-4-update-27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7"/>
              </a:rPr>
              <a:t>https://www.reuters.com/article/health-coronavirus-portugal/update-1-new-covid-19-lockdown-to-come-into-force-in-portugal-from-friday-idUSL1N2JO2H2</a:t>
            </a:r>
            <a:r>
              <a:rPr lang="en-US" sz="900" dirty="0"/>
              <a:t> </a:t>
            </a:r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7193208" y="4550432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3882745" y="4673023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916EA98-C775-42BF-818A-6947299B002E}"/>
              </a:ext>
            </a:extLst>
          </p:cNvPr>
          <p:cNvSpPr txBox="1"/>
          <p:nvPr/>
        </p:nvSpPr>
        <p:spPr>
          <a:xfrm>
            <a:off x="2689927" y="265294"/>
            <a:ext cx="8373446" cy="10156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arch, and were reopened briefly (preschool and grades 11 &amp; 12) before the summer without any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in September, followed by a stee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The country was put under partial lockdown (Nov 9) (Lisbon and Porto regions, schools remained open), and cases fell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briefly for the Christmas break, but cases began to climb regardless, and schools reopened in early Ja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The country was put under lockdown on Jan 15, but schools remained open</a:t>
            </a:r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2443F3C8-0EA0-4562-982A-2998E9617564}"/>
              </a:ext>
            </a:extLst>
          </p:cNvPr>
          <p:cNvSpPr/>
          <p:nvPr/>
        </p:nvSpPr>
        <p:spPr>
          <a:xfrm rot="5400000">
            <a:off x="5316516" y="4585157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08BB4B9A-BF0A-4D47-8EBB-DF3CC4A8DB91}"/>
              </a:ext>
            </a:extLst>
          </p:cNvPr>
          <p:cNvSpPr/>
          <p:nvPr/>
        </p:nvSpPr>
        <p:spPr>
          <a:xfrm rot="5400000">
            <a:off x="5572152" y="4550432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69617363-28CA-4712-AFBE-C6CB53D9F48F}"/>
              </a:ext>
            </a:extLst>
          </p:cNvPr>
          <p:cNvSpPr/>
          <p:nvPr/>
        </p:nvSpPr>
        <p:spPr>
          <a:xfrm rot="5400000">
            <a:off x="9277980" y="3168240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Arrow: Right 17">
            <a:extLst>
              <a:ext uri="{FF2B5EF4-FFF2-40B4-BE49-F238E27FC236}">
                <a16:creationId xmlns:a16="http://schemas.microsoft.com/office/drawing/2014/main" id="{436A6812-429E-4AE6-AF35-4651014E45B5}"/>
              </a:ext>
            </a:extLst>
          </p:cNvPr>
          <p:cNvSpPr/>
          <p:nvPr/>
        </p:nvSpPr>
        <p:spPr>
          <a:xfrm rot="5400000">
            <a:off x="9718419" y="2531556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ECBD6962-7599-4A36-BA42-0B985E2FA809}"/>
              </a:ext>
            </a:extLst>
          </p:cNvPr>
          <p:cNvSpPr/>
          <p:nvPr/>
        </p:nvSpPr>
        <p:spPr>
          <a:xfrm rot="5400000">
            <a:off x="9870569" y="1194279"/>
            <a:ext cx="457200" cy="180975"/>
          </a:xfrm>
          <a:prstGeom prst="rightArrow">
            <a:avLst/>
          </a:prstGeom>
          <a:solidFill>
            <a:schemeClr val="bg1">
              <a:lumMod val="65000"/>
              <a:alpha val="40000"/>
            </a:schemeClr>
          </a:solidFill>
          <a:ln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0" name="Arrow: Right 19">
            <a:extLst>
              <a:ext uri="{FF2B5EF4-FFF2-40B4-BE49-F238E27FC236}">
                <a16:creationId xmlns:a16="http://schemas.microsoft.com/office/drawing/2014/main" id="{061299BA-229D-47D1-B03E-03843F6D8BDA}"/>
              </a:ext>
            </a:extLst>
          </p:cNvPr>
          <p:cNvSpPr/>
          <p:nvPr/>
        </p:nvSpPr>
        <p:spPr>
          <a:xfrm rot="5400000">
            <a:off x="8561790" y="2531556"/>
            <a:ext cx="457200" cy="180975"/>
          </a:xfrm>
          <a:prstGeom prst="rightArrow">
            <a:avLst/>
          </a:prstGeom>
          <a:solidFill>
            <a:schemeClr val="bg1">
              <a:lumMod val="65000"/>
              <a:alpha val="40000"/>
            </a:schemeClr>
          </a:solidFill>
          <a:ln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E3D626D-B751-4BC2-AE6D-60A33DD8DE8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46372035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ACC27CD-9A6B-4947-8000-32718294B6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9104" y="960928"/>
            <a:ext cx="7242048" cy="4004501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Belgiu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569939" cy="1354545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3/18</a:t>
            </a:r>
          </a:p>
          <a:p>
            <a:r>
              <a:rPr lang="en-US" sz="1600" dirty="0"/>
              <a:t>School reopening: 9/1</a:t>
            </a:r>
          </a:p>
          <a:p>
            <a:r>
              <a:rPr lang="en-US" sz="1600" dirty="0"/>
              <a:t>School closing (autumn break): 10/30 (</a:t>
            </a:r>
            <a:r>
              <a:rPr lang="en-US" sz="1600" dirty="0" err="1"/>
              <a:t>fri</a:t>
            </a:r>
            <a:r>
              <a:rPr lang="en-US" sz="1600" dirty="0"/>
              <a:t>)</a:t>
            </a:r>
          </a:p>
          <a:p>
            <a:r>
              <a:rPr lang="en-US" sz="1600" dirty="0"/>
              <a:t>School reopening: 11/16</a:t>
            </a:r>
          </a:p>
          <a:p>
            <a:r>
              <a:rPr lang="en-US" sz="1600" dirty="0"/>
              <a:t>School closing: 12/23</a:t>
            </a:r>
          </a:p>
          <a:p>
            <a:r>
              <a:rPr lang="en-US" sz="1600" dirty="0"/>
              <a:t>School reopening: 1/5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8524875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reuters.com/article/healthcoronavirus-belgium/belgian-schools-to-reopen-in-september-masks-mandatory-for-older-children-idUSL8N2FM3RK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politico.eu/article/belgium-announces-second-coronavirus-lockdown/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5"/>
              </a:rPr>
              <a:t>https://en.wikipedia.org/wiki/COVID-19_pandemic_in_Belgium</a:t>
            </a:r>
            <a:r>
              <a:rPr lang="en-US" sz="900" dirty="0"/>
              <a:t>  </a:t>
            </a:r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8850426" y="3583783"/>
            <a:ext cx="457200" cy="147637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6C3120-3238-4260-8908-0CE6FE62F4F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6DF51523-B666-4E06-96D8-036F89B0992A}"/>
              </a:ext>
            </a:extLst>
          </p:cNvPr>
          <p:cNvSpPr/>
          <p:nvPr/>
        </p:nvSpPr>
        <p:spPr>
          <a:xfrm rot="5400000">
            <a:off x="3938355" y="4222613"/>
            <a:ext cx="457200" cy="147637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id="{4ECEEEBA-7E3B-4F4F-A438-09AD8F383EEF}"/>
              </a:ext>
            </a:extLst>
          </p:cNvPr>
          <p:cNvSpPr/>
          <p:nvPr/>
        </p:nvSpPr>
        <p:spPr>
          <a:xfrm rot="5400000">
            <a:off x="7212363" y="4222613"/>
            <a:ext cx="457200" cy="147637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C5E070-1522-4AA9-8E90-370E58AF0527}"/>
              </a:ext>
            </a:extLst>
          </p:cNvPr>
          <p:cNvSpPr txBox="1"/>
          <p:nvPr/>
        </p:nvSpPr>
        <p:spPr>
          <a:xfrm>
            <a:off x="2689927" y="265294"/>
            <a:ext cx="6402907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arch, and were reopened in early September followed by a stee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again at the end of October as cases began to fall sharpl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in mid-November for a month, before closing again for Christmas break</a:t>
            </a:r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8398225" y="722663"/>
            <a:ext cx="457200" cy="147637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23501907-E4C0-4A79-BD31-8382068B8D7B}"/>
              </a:ext>
            </a:extLst>
          </p:cNvPr>
          <p:cNvSpPr/>
          <p:nvPr/>
        </p:nvSpPr>
        <p:spPr>
          <a:xfrm rot="5400000">
            <a:off x="9443807" y="3743518"/>
            <a:ext cx="457200" cy="147637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36EF9DC7-6886-47CC-BCB7-A6DDF551D93C}"/>
              </a:ext>
            </a:extLst>
          </p:cNvPr>
          <p:cNvSpPr/>
          <p:nvPr/>
        </p:nvSpPr>
        <p:spPr>
          <a:xfrm rot="5400000">
            <a:off x="9707240" y="3972118"/>
            <a:ext cx="457200" cy="147637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F3B41DC3-4148-4BF4-81CB-3D2894E526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03969035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315968D-74A3-4129-AE43-AA5136DCCE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1825" y="925488"/>
            <a:ext cx="7260050" cy="4127659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Ital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2127799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~3/5</a:t>
            </a:r>
          </a:p>
          <a:p>
            <a:r>
              <a:rPr lang="en-US" sz="1600" dirty="0"/>
              <a:t>School reopening: ~9/15</a:t>
            </a:r>
          </a:p>
          <a:p>
            <a:r>
              <a:rPr lang="en-US" sz="1600" dirty="0"/>
              <a:t>School closing: ~10/15</a:t>
            </a:r>
          </a:p>
          <a:p>
            <a:endParaRPr lang="en-US" sz="16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525780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edarabia.com/school-holidays-italy/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aa.com.tr/en/education/students-parents-fight-school-closures-in-italy/2069281</a:t>
            </a:r>
            <a:r>
              <a:rPr lang="en-US" sz="900" dirty="0"/>
              <a:t> </a:t>
            </a:r>
          </a:p>
          <a:p>
            <a:endParaRPr lang="en-US" sz="900" dirty="0"/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7739989" y="4096384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4175787" y="4174820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6C3120-3238-4260-8908-0CE6FE62F4F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sp>
        <p:nvSpPr>
          <p:cNvPr id="12" name="Arrow: Right 11">
            <a:extLst>
              <a:ext uri="{FF2B5EF4-FFF2-40B4-BE49-F238E27FC236}">
                <a16:creationId xmlns:a16="http://schemas.microsoft.com/office/drawing/2014/main" id="{47289111-6AF5-4C89-9A99-BDBD54005BE5}"/>
              </a:ext>
            </a:extLst>
          </p:cNvPr>
          <p:cNvSpPr/>
          <p:nvPr/>
        </p:nvSpPr>
        <p:spPr>
          <a:xfrm rot="5400000">
            <a:off x="8357262" y="3127431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17D693E-5E84-45EB-8C9C-6C851443AD6A}"/>
              </a:ext>
            </a:extLst>
          </p:cNvPr>
          <p:cNvSpPr txBox="1"/>
          <p:nvPr/>
        </p:nvSpPr>
        <p:spPr>
          <a:xfrm>
            <a:off x="2689927" y="265294"/>
            <a:ext cx="6869060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arch, and were reopened in early September followed by a stee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again in mid-October followed by a drop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main closed as of early January, but the case count has not decreased to the previous baseline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87AFB3F2-1FA3-42C8-A298-2257FCB55E5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98902222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333D767-A6D4-4940-9569-420F34651A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3603" y="947806"/>
            <a:ext cx="7267766" cy="405822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Czech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3260501" cy="1354545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3/10</a:t>
            </a:r>
          </a:p>
          <a:p>
            <a:r>
              <a:rPr lang="en-US" sz="1600" dirty="0"/>
              <a:t>School reopening: ~9/1</a:t>
            </a:r>
          </a:p>
          <a:p>
            <a:r>
              <a:rPr lang="en-US" sz="1600" dirty="0"/>
              <a:t>School closing: ~10/12</a:t>
            </a:r>
          </a:p>
          <a:p>
            <a:r>
              <a:rPr lang="en-US" sz="1600" dirty="0"/>
              <a:t>School reopening: 11/12-11/25 (primary schools first)</a:t>
            </a:r>
          </a:p>
          <a:p>
            <a:r>
              <a:rPr lang="en-US" sz="1600" dirty="0"/>
              <a:t>School closing: 12/18</a:t>
            </a:r>
          </a:p>
          <a:p>
            <a:r>
              <a:rPr lang="en-US" sz="1600" dirty="0"/>
              <a:t>School reopening: 1/3</a:t>
            </a:r>
          </a:p>
          <a:p>
            <a:endParaRPr lang="en-US" sz="1600" dirty="0"/>
          </a:p>
          <a:p>
            <a:endParaRPr lang="en-US" sz="16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7374943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usnews.com/news/world/articles/2020-10-12/czech-government-closing-bars-shifting-schools-to-distance-learning-amid-covid-19-surge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studyinternational.com/news/reopen-elementary-schools-czechs/</a:t>
            </a:r>
            <a:endParaRPr lang="en-US" sz="900" dirty="0"/>
          </a:p>
          <a:p>
            <a:r>
              <a:rPr lang="en-US" sz="900" dirty="0">
                <a:hlinkClick r:id="rId5"/>
              </a:rPr>
              <a:t>https://www.irishtimes.com/news/world/europe/czechs-reverse-relaxation-of-covid-19-restrictions-to-avert-christmas-surge-1.4437636</a:t>
            </a:r>
            <a:endParaRPr lang="en-US" sz="900" dirty="0"/>
          </a:p>
          <a:p>
            <a:r>
              <a:rPr lang="en-US" sz="900" dirty="0">
                <a:hlinkClick r:id="rId6"/>
              </a:rPr>
              <a:t>https://avoid-crowds.com/2021-czech-republic-school-vacations-public-holidays/</a:t>
            </a:r>
            <a:r>
              <a:rPr lang="en-US" sz="900" dirty="0"/>
              <a:t> </a:t>
            </a:r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7153151" y="4125803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3788969" y="4229690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6C3120-3238-4260-8908-0CE6FE62F4F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sp>
        <p:nvSpPr>
          <p:cNvPr id="9" name="Arrow: Right 8">
            <a:extLst>
              <a:ext uri="{FF2B5EF4-FFF2-40B4-BE49-F238E27FC236}">
                <a16:creationId xmlns:a16="http://schemas.microsoft.com/office/drawing/2014/main" id="{ACCB052E-EADE-42D0-BB2D-4FFE66739845}"/>
              </a:ext>
            </a:extLst>
          </p:cNvPr>
          <p:cNvSpPr/>
          <p:nvPr/>
        </p:nvSpPr>
        <p:spPr>
          <a:xfrm rot="5400000">
            <a:off x="7936916" y="2365867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id="{35DEE7C6-1109-46CA-AEDB-13C304046EF8}"/>
              </a:ext>
            </a:extLst>
          </p:cNvPr>
          <p:cNvSpPr/>
          <p:nvPr/>
        </p:nvSpPr>
        <p:spPr>
          <a:xfrm rot="5400000">
            <a:off x="9298991" y="1983773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7F76DD5F-1ED3-4495-ADF4-0D6CD56C359C}"/>
              </a:ext>
            </a:extLst>
          </p:cNvPr>
          <p:cNvSpPr/>
          <p:nvPr/>
        </p:nvSpPr>
        <p:spPr>
          <a:xfrm rot="5400000">
            <a:off x="8584615" y="2384918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Arrow: Right 12">
            <a:extLst>
              <a:ext uri="{FF2B5EF4-FFF2-40B4-BE49-F238E27FC236}">
                <a16:creationId xmlns:a16="http://schemas.microsoft.com/office/drawing/2014/main" id="{CF01D7A1-3F91-4468-BDA4-D30D764DA35B}"/>
              </a:ext>
            </a:extLst>
          </p:cNvPr>
          <p:cNvSpPr/>
          <p:nvPr/>
        </p:nvSpPr>
        <p:spPr>
          <a:xfrm rot="5400000">
            <a:off x="9556165" y="1339934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60B002E-91FD-4C84-8259-D50D541FEEDB}"/>
              </a:ext>
            </a:extLst>
          </p:cNvPr>
          <p:cNvSpPr txBox="1"/>
          <p:nvPr/>
        </p:nvSpPr>
        <p:spPr>
          <a:xfrm>
            <a:off x="2689927" y="265294"/>
            <a:ext cx="6546985" cy="8309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arch, and were reopened in early September followed by a stee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again in mid-October followed by a drop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again in mid-November followed by a stee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for Christmas break (12/18-1/3) as part of a stringent lockdown and a rise in cases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F5A64DA-2B61-4D8A-B7AD-729FF658CAD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80821657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30A592B-8A96-4F9F-9E45-2F79C19596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9770" y="1330258"/>
            <a:ext cx="7298627" cy="410451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Taiwan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280406"/>
            <a:ext cx="488632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/>
              <a:t>https://www.cfr.org/backgrounder/how-countries-are-reopening-schools-during-pandemic</a:t>
            </a:r>
          </a:p>
          <a:p>
            <a:endParaRPr lang="en-US" sz="9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7FA4066-9CDA-4EA7-89BD-C35C880B30C6}"/>
              </a:ext>
            </a:extLst>
          </p:cNvPr>
          <p:cNvSpPr txBox="1"/>
          <p:nvPr/>
        </p:nvSpPr>
        <p:spPr>
          <a:xfrm>
            <a:off x="2689927" y="265294"/>
            <a:ext cx="476117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Most schools in Taiwan have remained open throughout the pandemi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4F2DA78-2679-4407-9054-6121F50C966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85770461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Japa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3050951" cy="1354545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2/28</a:t>
            </a:r>
          </a:p>
          <a:p>
            <a:r>
              <a:rPr lang="en-US" sz="1600" dirty="0"/>
              <a:t>School reopening: ~6/1</a:t>
            </a:r>
          </a:p>
          <a:p>
            <a:r>
              <a:rPr lang="en-US" sz="1600" dirty="0"/>
              <a:t>School closing (summer): 7/20</a:t>
            </a:r>
          </a:p>
          <a:p>
            <a:r>
              <a:rPr lang="en-US" sz="1600" dirty="0"/>
              <a:t>School reopening: ~9/1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704850" y="6216540"/>
            <a:ext cx="803910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2"/>
              </a:rPr>
              <a:t>https://www.asumag.com/safety-security/crisis-disaster-planning-management/article/21124391/coronavirus-threat-prompts-japan-to-close-schools-nationwide</a:t>
            </a:r>
          </a:p>
          <a:p>
            <a:r>
              <a:rPr lang="en-US" sz="900" dirty="0">
                <a:hlinkClick r:id="rId2"/>
              </a:rPr>
              <a:t>https://www.usnews.com/news/best-countries/articles/2020-07-22/how-countries-reopened-schools-amid-the-coronavirus-pandemic</a:t>
            </a:r>
          </a:p>
          <a:p>
            <a:r>
              <a:rPr lang="en-US" sz="900" dirty="0">
                <a:hlinkClick r:id="rId2"/>
              </a:rPr>
              <a:t>https://www.cbsnews.com/news/japan-schools-back-in-session-coronavirus-pandemic-covid-19/</a:t>
            </a:r>
            <a:r>
              <a:rPr lang="en-US" sz="900" dirty="0"/>
              <a:t>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A1C1564-5E05-41F0-9BE2-A1832D5E1BA9}"/>
              </a:ext>
            </a:extLst>
          </p:cNvPr>
          <p:cNvSpPr txBox="1"/>
          <p:nvPr/>
        </p:nvSpPr>
        <p:spPr>
          <a:xfrm>
            <a:off x="2689927" y="265294"/>
            <a:ext cx="5801973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February, and were reopened in June followed by a stee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for the summer in July, followed by a drop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again in early September followed by a steep rise in case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DEEA279C-6195-4ED6-B191-522383A4EF1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99770" y="1334855"/>
            <a:ext cx="7283196" cy="4073652"/>
          </a:xfrm>
          <a:prstGeom prst="rect">
            <a:avLst/>
          </a:prstGeom>
        </p:spPr>
      </p:pic>
      <p:sp>
        <p:nvSpPr>
          <p:cNvPr id="14" name="Arrow: Right 13">
            <a:extLst>
              <a:ext uri="{FF2B5EF4-FFF2-40B4-BE49-F238E27FC236}">
                <a16:creationId xmlns:a16="http://schemas.microsoft.com/office/drawing/2014/main" id="{C8644981-923D-4003-8A52-348912F31DE1}"/>
              </a:ext>
            </a:extLst>
          </p:cNvPr>
          <p:cNvSpPr/>
          <p:nvPr/>
        </p:nvSpPr>
        <p:spPr>
          <a:xfrm rot="5400000">
            <a:off x="7491433" y="4221242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FF73311E-EEC7-49B4-914F-26CE1371D2FB}"/>
              </a:ext>
            </a:extLst>
          </p:cNvPr>
          <p:cNvSpPr/>
          <p:nvPr/>
        </p:nvSpPr>
        <p:spPr>
          <a:xfrm rot="5400000">
            <a:off x="4081462" y="4635391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67DB894F-A2C6-4FCD-B4E5-6788E1991FED}"/>
              </a:ext>
            </a:extLst>
          </p:cNvPr>
          <p:cNvSpPr/>
          <p:nvPr/>
        </p:nvSpPr>
        <p:spPr>
          <a:xfrm rot="5400000">
            <a:off x="5924551" y="4630817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C422A9B8-5FA9-438B-9A92-391BFC4ED6AE}"/>
              </a:ext>
            </a:extLst>
          </p:cNvPr>
          <p:cNvSpPr/>
          <p:nvPr/>
        </p:nvSpPr>
        <p:spPr>
          <a:xfrm rot="5400000">
            <a:off x="6722280" y="4324541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19D9DA6D-2A3C-4C62-BC39-2915B526F0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166197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DDF700-BE5C-4A7E-8B86-13E075702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thodology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A9694F-A751-4430-8C6E-AD93AD233D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ase count kinetics were obtained from Our World In </a:t>
            </a:r>
            <a:r>
              <a:rPr lang="en-US"/>
              <a:t>Data on 1/16/21 (</a:t>
            </a:r>
            <a:r>
              <a:rPr lang="en-US" dirty="0"/>
              <a:t>derived originally from the Johns Hopkins University CSSE COVID database)</a:t>
            </a:r>
          </a:p>
          <a:p>
            <a:r>
              <a:rPr lang="en-US" dirty="0"/>
              <a:t>School reopening and closing dates were obtained from news articles  and Wikipedia articles, identified by google searches with the country name, and the words “school reopening”, “school closing” and “lockdown”</a:t>
            </a:r>
          </a:p>
          <a:p>
            <a:r>
              <a:rPr lang="en-US" dirty="0"/>
              <a:t>Lockdowns that did not involve school closure were also noted when they occurred</a:t>
            </a:r>
          </a:p>
        </p:txBody>
      </p:sp>
    </p:spTree>
    <p:extLst>
      <p:ext uri="{BB962C8B-B14F-4D97-AF65-F5344CB8AC3E}">
        <p14:creationId xmlns:p14="http://schemas.microsoft.com/office/powerpoint/2010/main" val="190480179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D5D9BAF-6B8E-49E4-A89C-894F7AE527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9770" y="1399889"/>
            <a:ext cx="7267766" cy="405822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South Kore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8" y="1716171"/>
            <a:ext cx="3489101" cy="1712829"/>
          </a:xfrm>
        </p:spPr>
        <p:txBody>
          <a:bodyPr>
            <a:noAutofit/>
          </a:bodyPr>
          <a:lstStyle/>
          <a:p>
            <a:r>
              <a:rPr lang="en-US" sz="1600" dirty="0"/>
              <a:t>School closing:~3/5</a:t>
            </a:r>
          </a:p>
          <a:p>
            <a:r>
              <a:rPr lang="en-US" sz="1600" dirty="0"/>
              <a:t>School reopening: 5/20-6/1</a:t>
            </a:r>
          </a:p>
          <a:p>
            <a:r>
              <a:rPr lang="en-US" sz="1600" dirty="0"/>
              <a:t>School closing: 8/25 (Seoul area)</a:t>
            </a:r>
          </a:p>
          <a:p>
            <a:r>
              <a:rPr lang="en-US" sz="1600" dirty="0"/>
              <a:t>School reopening: 9/21 (Seoul area)</a:t>
            </a:r>
          </a:p>
          <a:p>
            <a:r>
              <a:rPr lang="en-US" sz="1600" dirty="0"/>
              <a:t>School closing: 12/13 (Seoul area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457199" y="6136719"/>
            <a:ext cx="75152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wsj.com/articles/remote-learning-in-south-korea-becomes-a-fixture-of-pandemic-life-11599668494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reuters.com/article/health-coronavirus-southkorea/south-korea-orders-schools-to-shut-as-covid-19-cases-spike-idUSKBN28O09O</a:t>
            </a:r>
            <a:endParaRPr lang="en-US" sz="900" dirty="0"/>
          </a:p>
          <a:p>
            <a:r>
              <a:rPr lang="en-US" sz="900" dirty="0">
                <a:hlinkClick r:id="rId5"/>
              </a:rPr>
              <a:t>https://www.bbc.com/news/world-asia-53901707</a:t>
            </a:r>
            <a:r>
              <a:rPr lang="en-US" sz="900" dirty="0"/>
              <a:t>   </a:t>
            </a:r>
          </a:p>
          <a:p>
            <a:r>
              <a:rPr lang="en-US" sz="900" dirty="0">
                <a:hlinkClick r:id="rId6"/>
              </a:rPr>
              <a:t>https://www.koreatimes.co.kr/www/nation/2020/09/181_296397.html</a:t>
            </a:r>
            <a:r>
              <a:rPr lang="en-US" sz="900" dirty="0"/>
              <a:t> </a:t>
            </a:r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5528604" y="4635747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9117849" y="2074356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1B2AC5C-519D-43A5-A533-9BCE4EE33C40}"/>
              </a:ext>
            </a:extLst>
          </p:cNvPr>
          <p:cNvSpPr txBox="1"/>
          <p:nvPr/>
        </p:nvSpPr>
        <p:spPr>
          <a:xfrm>
            <a:off x="2689927" y="265294"/>
            <a:ext cx="6715749" cy="101566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arch, and were reopened in May- June, with case counts remaining low for a whil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Case counts in the Seoul area spiked in August, and local school closures followe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New cases in the Seoul area decreased after schools were close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in the Seoul area were reopened in late September, followed by a stee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in the Seoul area were once again closed in mid-December, followed by a drop in cases</a:t>
            </a:r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991126E7-160F-4F6C-A05E-C8CEE789E11F}"/>
              </a:ext>
            </a:extLst>
          </p:cNvPr>
          <p:cNvSpPr/>
          <p:nvPr/>
        </p:nvSpPr>
        <p:spPr>
          <a:xfrm rot="5400000">
            <a:off x="3986210" y="4250694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9C399B00-1EDC-4EAA-B12E-56F47335CD69}"/>
              </a:ext>
            </a:extLst>
          </p:cNvPr>
          <p:cNvSpPr/>
          <p:nvPr/>
        </p:nvSpPr>
        <p:spPr>
          <a:xfrm rot="5400000">
            <a:off x="7262810" y="3517033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D33C73D3-4139-4131-A1D8-62729A9D300A}"/>
              </a:ext>
            </a:extLst>
          </p:cNvPr>
          <p:cNvSpPr/>
          <p:nvPr/>
        </p:nvSpPr>
        <p:spPr>
          <a:xfrm rot="5400000">
            <a:off x="7690781" y="4359522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F9AFA0D4-9ED7-4A03-ADCD-5E48598598A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98475713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13EB2D6-F854-4CE6-A79D-F757C6A9B2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9770" y="1384458"/>
            <a:ext cx="7260050" cy="4089083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Canad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2"/>
            <a:ext cx="2689927" cy="788904"/>
          </a:xfrm>
        </p:spPr>
        <p:txBody>
          <a:bodyPr>
            <a:normAutofit/>
          </a:bodyPr>
          <a:lstStyle/>
          <a:p>
            <a:r>
              <a:rPr lang="en-US" sz="1600" dirty="0"/>
              <a:t>School closing: ~3/15</a:t>
            </a:r>
          </a:p>
          <a:p>
            <a:r>
              <a:rPr lang="en-US" sz="1600" dirty="0"/>
              <a:t>School reopening: ~9/2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00742" y="6223373"/>
            <a:ext cx="7847958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theglobeandmail.com/canada/article-ontario-to-close-all-public-schools-for-two-weeks-after-march-break/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reuters.com/article/us-health-coronavirus-canada-education/coronavirus-angst-as-canadian-schools-start-to-open-idUSKBN25U1N4</a:t>
            </a:r>
            <a:r>
              <a:rPr lang="en-US" sz="900" dirty="0"/>
              <a:t> </a:t>
            </a:r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7235164" y="4553584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4466299" y="4667884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F92CE67-3A94-4405-A8C8-D5F8B6CFE900}"/>
              </a:ext>
            </a:extLst>
          </p:cNvPr>
          <p:cNvSpPr txBox="1"/>
          <p:nvPr/>
        </p:nvSpPr>
        <p:spPr>
          <a:xfrm>
            <a:off x="2689927" y="357627"/>
            <a:ext cx="668824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id-March, and were reopened in early September followed by a steep rise in cases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4F0A0DF-AEEC-4E44-A76C-6CCF3A71B67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42768659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Autofit/>
          </a:bodyPr>
          <a:lstStyle/>
          <a:p>
            <a:pPr algn="ctr"/>
            <a:r>
              <a:rPr lang="en-US" sz="4000" dirty="0"/>
              <a:t>U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1931904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~3/15</a:t>
            </a:r>
          </a:p>
          <a:p>
            <a:r>
              <a:rPr lang="en-US" sz="1600" dirty="0"/>
              <a:t>School reopening: 7/24-9/15 (varied by state)</a:t>
            </a:r>
          </a:p>
          <a:p>
            <a:r>
              <a:rPr lang="en-US" sz="1600" dirty="0"/>
              <a:t>School closing: ~12/20 (Christmas break)</a:t>
            </a:r>
          </a:p>
          <a:p>
            <a:r>
              <a:rPr lang="en-US" sz="1600" dirty="0"/>
              <a:t>School reopening: ~1/5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361949" y="6344801"/>
            <a:ext cx="737494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2"/>
              </a:rPr>
              <a:t>https://tn.chalkbeat.org/2020/7/31/21349881/one-of-americas-first-states-to-reopen-schools-in-person-tennessee-serves-as-covid-experiment</a:t>
            </a:r>
            <a:r>
              <a:rPr lang="en-US" sz="900" dirty="0"/>
              <a:t> </a:t>
            </a:r>
          </a:p>
          <a:p>
            <a:endParaRPr lang="en-US" sz="900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2D423D8-0609-4AD7-AD73-A87A34084E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99770" y="1343409"/>
            <a:ext cx="7306342" cy="410451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CC851356-B742-4F65-A6F0-C1C05FA03DF7}"/>
              </a:ext>
            </a:extLst>
          </p:cNvPr>
          <p:cNvSpPr txBox="1"/>
          <p:nvPr/>
        </p:nvSpPr>
        <p:spPr>
          <a:xfrm>
            <a:off x="2689927" y="357627"/>
            <a:ext cx="6688241" cy="27699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mid-March, and were reopened in early September followed by a steep rise in cases</a:t>
            </a:r>
          </a:p>
        </p:txBody>
      </p:sp>
      <p:sp>
        <p:nvSpPr>
          <p:cNvPr id="12" name="Arrow: Right 11">
            <a:extLst>
              <a:ext uri="{FF2B5EF4-FFF2-40B4-BE49-F238E27FC236}">
                <a16:creationId xmlns:a16="http://schemas.microsoft.com/office/drawing/2014/main" id="{0142197C-66CE-4F2C-BD9F-D55B62BD751D}"/>
              </a:ext>
            </a:extLst>
          </p:cNvPr>
          <p:cNvSpPr/>
          <p:nvPr/>
        </p:nvSpPr>
        <p:spPr>
          <a:xfrm rot="5400000">
            <a:off x="7181851" y="4048760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Arrow: Right 13">
            <a:extLst>
              <a:ext uri="{FF2B5EF4-FFF2-40B4-BE49-F238E27FC236}">
                <a16:creationId xmlns:a16="http://schemas.microsoft.com/office/drawing/2014/main" id="{6CD08DB2-4DC0-4A1D-AF80-FCF66F3115A8}"/>
              </a:ext>
            </a:extLst>
          </p:cNvPr>
          <p:cNvSpPr/>
          <p:nvPr/>
        </p:nvSpPr>
        <p:spPr>
          <a:xfrm rot="5400000">
            <a:off x="4452937" y="4639310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BF0B7CEE-221D-40DA-BBD6-8427EA86F693}"/>
              </a:ext>
            </a:extLst>
          </p:cNvPr>
          <p:cNvSpPr/>
          <p:nvPr/>
        </p:nvSpPr>
        <p:spPr>
          <a:xfrm rot="5400000">
            <a:off x="9149567" y="1548191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62EC32E9-9E1A-4477-AD2B-970623774734}"/>
              </a:ext>
            </a:extLst>
          </p:cNvPr>
          <p:cNvSpPr/>
          <p:nvPr/>
        </p:nvSpPr>
        <p:spPr>
          <a:xfrm rot="5400000">
            <a:off x="9486901" y="1481522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8B2556DA-891A-4A31-840C-96DE88C1786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47998" y="1569692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3335401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Isra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1354545"/>
          </a:xfrm>
        </p:spPr>
        <p:txBody>
          <a:bodyPr>
            <a:normAutofit fontScale="77500" lnSpcReduction="20000"/>
          </a:bodyPr>
          <a:lstStyle/>
          <a:p>
            <a:r>
              <a:rPr lang="en-US" sz="1600" dirty="0"/>
              <a:t>Schools open: 5/15</a:t>
            </a:r>
          </a:p>
          <a:p>
            <a:r>
              <a:rPr lang="en-US" sz="1600" dirty="0"/>
              <a:t>School closing: 6/3</a:t>
            </a:r>
          </a:p>
          <a:p>
            <a:r>
              <a:rPr lang="en-US" sz="1600" dirty="0"/>
              <a:t>School reopening: 9/1</a:t>
            </a:r>
          </a:p>
          <a:p>
            <a:r>
              <a:rPr lang="en-US" sz="1600" dirty="0"/>
              <a:t>School closing: 9/18</a:t>
            </a:r>
          </a:p>
          <a:p>
            <a:r>
              <a:rPr lang="en-US" sz="1600" dirty="0"/>
              <a:t>Schools reopened: 11/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1B8E3E1-EE41-4C00-AB3C-ECEE838DD2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9901" y="960929"/>
            <a:ext cx="7279767" cy="402964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7648575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npr.org/sections/coronavirus-live-updates/2020/06/03/868507524/israel-orders-schools-to-close-when-covid-19-cases-are-discovered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timesofisrael.com/school-is-back-in-session-for-grades-1-4-as-lockdown-eased-synagogues-reopen/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5"/>
              </a:rPr>
              <a:t>https://www.wsj.com/articles/israelis-fear-schools-reopened-too-soon-as-covid-19-cases-climb-11594760001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6"/>
              </a:rPr>
              <a:t>http://www.xinhuanet.com/english/2020-09/13/c_139363901.htm</a:t>
            </a:r>
            <a:r>
              <a:rPr lang="en-US" sz="900" dirty="0"/>
              <a:t> </a:t>
            </a:r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4751652" y="4281024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00F24CB1-1F83-4298-AEC4-91A0EB5D4945}"/>
              </a:ext>
            </a:extLst>
          </p:cNvPr>
          <p:cNvSpPr/>
          <p:nvPr/>
        </p:nvSpPr>
        <p:spPr>
          <a:xfrm rot="5400000">
            <a:off x="5051228" y="4234759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Arrow: Right 7">
            <a:extLst>
              <a:ext uri="{FF2B5EF4-FFF2-40B4-BE49-F238E27FC236}">
                <a16:creationId xmlns:a16="http://schemas.microsoft.com/office/drawing/2014/main" id="{C03A6B98-F4DB-4CD5-A038-C24DBC8A27BC}"/>
              </a:ext>
            </a:extLst>
          </p:cNvPr>
          <p:cNvSpPr/>
          <p:nvPr/>
        </p:nvSpPr>
        <p:spPr>
          <a:xfrm rot="5400000">
            <a:off x="8129586" y="3938124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636FC9A4-6404-466B-B3D4-FC821A7BA5CB}"/>
              </a:ext>
            </a:extLst>
          </p:cNvPr>
          <p:cNvSpPr/>
          <p:nvPr/>
        </p:nvSpPr>
        <p:spPr>
          <a:xfrm rot="5400000">
            <a:off x="6807551" y="3455803"/>
            <a:ext cx="457200" cy="180976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7231412" y="1981774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C0D04F7-423A-4A0C-B92D-EC577A8AA27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93104"/>
          <a:stretch/>
        </p:blipFill>
        <p:spPr>
          <a:xfrm>
            <a:off x="3009901" y="5247136"/>
            <a:ext cx="7374944" cy="32016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77F71D8-C600-4164-83DE-D89625A9419A}"/>
              </a:ext>
            </a:extLst>
          </p:cNvPr>
          <p:cNvSpPr txBox="1"/>
          <p:nvPr/>
        </p:nvSpPr>
        <p:spPr>
          <a:xfrm>
            <a:off x="2689927" y="97526"/>
            <a:ext cx="4792017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Aborted school reopening in spring following detection of local cluste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 reopening in Sept followed by a wave of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 closing followed by abatement of wav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 reopening in Nov followed by a wave of cases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48597B69-64CD-4D85-A503-CE4A07AD5892}"/>
              </a:ext>
            </a:extLst>
          </p:cNvPr>
          <p:cNvGrpSpPr/>
          <p:nvPr/>
        </p:nvGrpSpPr>
        <p:grpSpPr>
          <a:xfrm>
            <a:off x="13273004" y="603287"/>
            <a:ext cx="1896136" cy="1697575"/>
            <a:chOff x="413347" y="3652651"/>
            <a:chExt cx="1896136" cy="1697575"/>
          </a:xfrm>
        </p:grpSpPr>
        <p:sp>
          <p:nvSpPr>
            <p:cNvPr id="14" name="Arrow: Right 13">
              <a:extLst>
                <a:ext uri="{FF2B5EF4-FFF2-40B4-BE49-F238E27FC236}">
                  <a16:creationId xmlns:a16="http://schemas.microsoft.com/office/drawing/2014/main" id="{8D9C36CD-F079-4A5A-B81F-5D2440E2F6A5}"/>
                </a:ext>
              </a:extLst>
            </p:cNvPr>
            <p:cNvSpPr/>
            <p:nvPr/>
          </p:nvSpPr>
          <p:spPr>
            <a:xfrm rot="5400000">
              <a:off x="275235" y="3790763"/>
              <a:ext cx="457200" cy="180976"/>
            </a:xfrm>
            <a:prstGeom prst="rightArrow">
              <a:avLst/>
            </a:prstGeom>
            <a:solidFill>
              <a:srgbClr val="4472C4">
                <a:alpha val="40000"/>
              </a:srgbClr>
            </a:solidFill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Arrow: Right 14">
              <a:extLst>
                <a:ext uri="{FF2B5EF4-FFF2-40B4-BE49-F238E27FC236}">
                  <a16:creationId xmlns:a16="http://schemas.microsoft.com/office/drawing/2014/main" id="{ACF43544-08B3-44B5-ADDD-D3C7780450A8}"/>
                </a:ext>
              </a:extLst>
            </p:cNvPr>
            <p:cNvSpPr/>
            <p:nvPr/>
          </p:nvSpPr>
          <p:spPr>
            <a:xfrm rot="5400000">
              <a:off x="275235" y="4408030"/>
              <a:ext cx="457200" cy="180975"/>
            </a:xfrm>
            <a:prstGeom prst="rightArrow">
              <a:avLst/>
            </a:prstGeom>
            <a:solidFill>
              <a:srgbClr val="FF3B3B">
                <a:alpha val="40000"/>
              </a:srgbClr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Arrow: Right 15">
              <a:extLst>
                <a:ext uri="{FF2B5EF4-FFF2-40B4-BE49-F238E27FC236}">
                  <a16:creationId xmlns:a16="http://schemas.microsoft.com/office/drawing/2014/main" id="{DCC4EABB-953D-4F0C-BF96-E23018D71909}"/>
                </a:ext>
              </a:extLst>
            </p:cNvPr>
            <p:cNvSpPr/>
            <p:nvPr/>
          </p:nvSpPr>
          <p:spPr>
            <a:xfrm rot="5400000">
              <a:off x="275235" y="5025296"/>
              <a:ext cx="457200" cy="180975"/>
            </a:xfrm>
            <a:prstGeom prst="rightArrow">
              <a:avLst/>
            </a:prstGeom>
            <a:solidFill>
              <a:schemeClr val="bg1">
                <a:lumMod val="65000"/>
                <a:alpha val="40000"/>
              </a:schemeClr>
            </a:solidFill>
            <a:ln>
              <a:solidFill>
                <a:schemeClr val="bg2">
                  <a:lumMod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1D0CFF8-A991-4F0B-8F17-82021AABD490}"/>
                </a:ext>
              </a:extLst>
            </p:cNvPr>
            <p:cNvSpPr txBox="1"/>
            <p:nvPr/>
          </p:nvSpPr>
          <p:spPr>
            <a:xfrm>
              <a:off x="594832" y="3685097"/>
              <a:ext cx="1624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chool opening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D4F11BFD-8743-488D-8126-356CD258A9CE}"/>
                </a:ext>
              </a:extLst>
            </p:cNvPr>
            <p:cNvSpPr txBox="1"/>
            <p:nvPr/>
          </p:nvSpPr>
          <p:spPr>
            <a:xfrm>
              <a:off x="634568" y="4240663"/>
              <a:ext cx="1505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chool closing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3E44F59-BA64-4901-A4B8-BFAF750A8AD2}"/>
                </a:ext>
              </a:extLst>
            </p:cNvPr>
            <p:cNvSpPr txBox="1"/>
            <p:nvPr/>
          </p:nvSpPr>
          <p:spPr>
            <a:xfrm>
              <a:off x="685320" y="4796228"/>
              <a:ext cx="1624163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Lockdown </a:t>
              </a:r>
            </a:p>
            <a:p>
              <a:r>
                <a:rPr lang="en-US" sz="1200" dirty="0"/>
                <a:t>(schools remain open)</a:t>
              </a:r>
            </a:p>
          </p:txBody>
        </p:sp>
      </p:grpSp>
      <p:pic>
        <p:nvPicPr>
          <p:cNvPr id="21" name="Picture 20">
            <a:extLst>
              <a:ext uri="{FF2B5EF4-FFF2-40B4-BE49-F238E27FC236}">
                <a16:creationId xmlns:a16="http://schemas.microsoft.com/office/drawing/2014/main" id="{5CEEE69E-9A28-4651-B30F-07C05A93FB9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4144437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B213A164-77DB-4C22-A348-65A9F216C1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612"/>
          <a:stretch/>
        </p:blipFill>
        <p:spPr>
          <a:xfrm>
            <a:off x="3399770" y="1541698"/>
            <a:ext cx="7374944" cy="405703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Pakista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1354545"/>
          </a:xfrm>
        </p:spPr>
        <p:txBody>
          <a:bodyPr>
            <a:normAutofit/>
          </a:bodyPr>
          <a:lstStyle/>
          <a:p>
            <a:r>
              <a:rPr lang="en-US" sz="1600" dirty="0"/>
              <a:t>School closing: 6/3</a:t>
            </a:r>
          </a:p>
          <a:p>
            <a:r>
              <a:rPr lang="en-US" sz="1600" dirty="0"/>
              <a:t>School reopening: 9/15-9/30</a:t>
            </a:r>
          </a:p>
          <a:p>
            <a:r>
              <a:rPr lang="en-US" sz="1600" dirty="0"/>
              <a:t>School closing: 11/26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200" y="6015206"/>
            <a:ext cx="2099210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dawn.com/news/1555102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dawn.com/news/1578399</a:t>
            </a:r>
            <a:endParaRPr lang="en-US" sz="900" dirty="0"/>
          </a:p>
          <a:p>
            <a:r>
              <a:rPr lang="en-US" sz="900" dirty="0">
                <a:hlinkClick r:id="rId5"/>
              </a:rPr>
              <a:t>https://www.dawn.com/news/1591943</a:t>
            </a:r>
            <a:r>
              <a:rPr lang="en-US" sz="900" dirty="0"/>
              <a:t>  </a:t>
            </a:r>
          </a:p>
          <a:p>
            <a:endParaRPr lang="en-US" sz="900" dirty="0"/>
          </a:p>
          <a:p>
            <a:endParaRPr lang="en-US" sz="900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7381875" y="4583768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00F24CB1-1F83-4298-AEC4-91A0EB5D4945}"/>
              </a:ext>
            </a:extLst>
          </p:cNvPr>
          <p:cNvSpPr/>
          <p:nvPr/>
        </p:nvSpPr>
        <p:spPr>
          <a:xfrm rot="5400000">
            <a:off x="9133550" y="3208829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3818600" y="4812368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93104"/>
          <a:stretch/>
        </p:blipFill>
        <p:spPr>
          <a:xfrm>
            <a:off x="3399770" y="5695040"/>
            <a:ext cx="7374944" cy="32016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D851B201-02D7-4F49-A2E9-E4F3EA02456C}"/>
              </a:ext>
            </a:extLst>
          </p:cNvPr>
          <p:cNvSpPr txBox="1"/>
          <p:nvPr/>
        </p:nvSpPr>
        <p:spPr>
          <a:xfrm>
            <a:off x="2689927" y="265294"/>
            <a:ext cx="5284652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 reopening in late Sept followed by a wave of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in late Nov, followed by abatement of the growth in case counts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154BAF20-38E7-4F18-8E31-198B7037EC2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0771118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1E7B76E-DE60-4245-8354-02C0259C79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924"/>
          <a:stretch/>
        </p:blipFill>
        <p:spPr>
          <a:xfrm>
            <a:off x="3402189" y="1371600"/>
            <a:ext cx="7317486" cy="399054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Ind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1354545"/>
          </a:xfrm>
        </p:spPr>
        <p:txBody>
          <a:bodyPr>
            <a:normAutofit/>
          </a:bodyPr>
          <a:lstStyle/>
          <a:p>
            <a:r>
              <a:rPr lang="en-US" sz="1600" dirty="0"/>
              <a:t>Schools closed: 3/25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FF2C3AB-6553-4F6D-809D-A13623B9A047}"/>
              </a:ext>
            </a:extLst>
          </p:cNvPr>
          <p:cNvSpPr/>
          <p:nvPr/>
        </p:nvSpPr>
        <p:spPr>
          <a:xfrm>
            <a:off x="571499" y="6110104"/>
            <a:ext cx="762952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>
                <a:hlinkClick r:id="rId3"/>
              </a:rPr>
              <a:t>https://en.wikipedia.org/wiki/COVID-19_pandemic_in_India</a:t>
            </a:r>
            <a:endParaRPr lang="en-US" sz="1000" dirty="0"/>
          </a:p>
          <a:p>
            <a:r>
              <a:rPr lang="en-US" sz="1000" dirty="0">
                <a:hlinkClick r:id="rId4"/>
              </a:rPr>
              <a:t>https://www.livemint.com/news/world/closing-down-schools-again-will-harm-320mn-students-worldwide-says-unicef-11607404867611.html</a:t>
            </a:r>
            <a:r>
              <a:rPr lang="en-US" sz="1000" dirty="0"/>
              <a:t>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0584362-83BA-44BE-B5F5-47DF6DBB6CD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93104"/>
          <a:stretch/>
        </p:blipFill>
        <p:spPr>
          <a:xfrm>
            <a:off x="3344731" y="5486400"/>
            <a:ext cx="7374944" cy="32016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898A9E05-385B-4723-BCBF-E91555A50D60}"/>
              </a:ext>
            </a:extLst>
          </p:cNvPr>
          <p:cNvSpPr txBox="1"/>
          <p:nvPr/>
        </p:nvSpPr>
        <p:spPr>
          <a:xfrm>
            <a:off x="2689927" y="265294"/>
            <a:ext cx="4417812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in India have been closed through the entire pandemic</a:t>
            </a:r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11479D4C-6D51-400B-9484-15013EAB6D7C}"/>
              </a:ext>
            </a:extLst>
          </p:cNvPr>
          <p:cNvSpPr/>
          <p:nvPr/>
        </p:nvSpPr>
        <p:spPr>
          <a:xfrm rot="5400000">
            <a:off x="3885275" y="4688544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CBD8548-7B9F-4E0C-8C06-2DFD34E3D1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5590417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Swede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365151" cy="1354545"/>
          </a:xfrm>
        </p:spPr>
        <p:txBody>
          <a:bodyPr>
            <a:normAutofit fontScale="92500" lnSpcReduction="10000"/>
          </a:bodyPr>
          <a:lstStyle/>
          <a:p>
            <a:r>
              <a:rPr lang="en-US" sz="1600" dirty="0"/>
              <a:t>Sweden has kept most schools open for the entire duration of the pandemic</a:t>
            </a:r>
          </a:p>
          <a:p>
            <a:r>
              <a:rPr lang="en-US" sz="1600" dirty="0"/>
              <a:t>School closing: 12/3 (high schools only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627697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2"/>
              </a:rPr>
              <a:t>https://www.voanews.com/covid-19-pandemic/sweden-closes-high-schools-until-early-january-stem-covid-19-infections</a:t>
            </a:r>
            <a:r>
              <a:rPr lang="en-US" sz="900" dirty="0"/>
              <a:t> </a:t>
            </a:r>
          </a:p>
          <a:p>
            <a:endParaRPr lang="en-US" sz="9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6C3120-3238-4260-8908-0CE6FE62F4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5238179-F247-4804-BFB4-B1DF2A5D67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96400" y="1039913"/>
            <a:ext cx="7311200" cy="3991928"/>
          </a:xfrm>
          <a:prstGeom prst="rect">
            <a:avLst/>
          </a:prstGeom>
        </p:spPr>
      </p:pic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8967789" y="1911434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1423DD5-3D62-4D8D-BC1F-91327D83A720}"/>
              </a:ext>
            </a:extLst>
          </p:cNvPr>
          <p:cNvGrpSpPr/>
          <p:nvPr/>
        </p:nvGrpSpPr>
        <p:grpSpPr>
          <a:xfrm>
            <a:off x="312826" y="3816247"/>
            <a:ext cx="2343148" cy="1294579"/>
            <a:chOff x="3976686" y="1149113"/>
            <a:chExt cx="2343148" cy="129457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96102C6-55E6-4456-BFA2-74E16410CA9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76686" y="1149113"/>
              <a:ext cx="2343148" cy="129457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5A4FADD-BC23-40D2-B7F9-F8B5D87D93D1}"/>
                </a:ext>
              </a:extLst>
            </p:cNvPr>
            <p:cNvSpPr txBox="1"/>
            <p:nvPr/>
          </p:nvSpPr>
          <p:spPr>
            <a:xfrm>
              <a:off x="5395910" y="1175810"/>
              <a:ext cx="6773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663300"/>
                  </a:solidFill>
                </a:rPr>
                <a:t>Sweden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735BA06-DB98-4DEF-ADED-B815B34D19C4}"/>
                </a:ext>
              </a:extLst>
            </p:cNvPr>
            <p:cNvSpPr txBox="1"/>
            <p:nvPr/>
          </p:nvSpPr>
          <p:spPr>
            <a:xfrm>
              <a:off x="5700161" y="209202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50000"/>
                      <a:lumOff val="50000"/>
                    </a:schemeClr>
                  </a:solidFill>
                </a:rPr>
                <a:t>India</a:t>
              </a: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2DFC0FD4-8649-49CD-8DE6-6121A565E244}"/>
              </a:ext>
            </a:extLst>
          </p:cNvPr>
          <p:cNvSpPr txBox="1"/>
          <p:nvPr/>
        </p:nvSpPr>
        <p:spPr>
          <a:xfrm>
            <a:off x="2689927" y="265294"/>
            <a:ext cx="5809219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weden has kept most schools open for the entire duration of the pandemic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Inset shows contrast with India, where schools have been closed for the entire duration 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0B0D06F0-86A4-4029-8BC6-45515E2F0DF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229418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Franc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689927" cy="1354545"/>
          </a:xfrm>
        </p:spPr>
        <p:txBody>
          <a:bodyPr>
            <a:normAutofit/>
          </a:bodyPr>
          <a:lstStyle/>
          <a:p>
            <a:r>
              <a:rPr lang="en-US" sz="1600" dirty="0"/>
              <a:t>School closing:3/17</a:t>
            </a:r>
          </a:p>
          <a:p>
            <a:r>
              <a:rPr lang="en-US" sz="1600" dirty="0"/>
              <a:t>School reopening: 5/11</a:t>
            </a:r>
          </a:p>
          <a:p>
            <a:r>
              <a:rPr lang="en-US" sz="1600" dirty="0"/>
              <a:t>Second lockdown: 10/29 (schools remain open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838199" y="6015206"/>
            <a:ext cx="7734302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2"/>
              </a:rPr>
              <a:t>https://www.nbcnews.com/health/health-news/70-cases-covid-19-french-schools-days-after-re-opening-n1209591</a:t>
            </a:r>
            <a:endParaRPr lang="en-US" sz="900" dirty="0"/>
          </a:p>
          <a:p>
            <a:r>
              <a:rPr lang="en-US" sz="900" dirty="0">
                <a:hlinkClick r:id="rId3"/>
              </a:rPr>
              <a:t>https://www.bbc.com/news/world-europe-54716993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thelocal.fr/20210104/analysis-is-france-right-to-keep-its-schools-open-during-pandemic</a:t>
            </a:r>
            <a:endParaRPr lang="en-US" sz="900" dirty="0"/>
          </a:p>
          <a:p>
            <a:r>
              <a:rPr lang="en-US" sz="900" dirty="0">
                <a:hlinkClick r:id="rId5"/>
              </a:rPr>
              <a:t>https://www.wsj.com/articles/contact-tracing-the-wests-big-hope-for-suppressing-covid-19-is-in-disarray-11600337670?mod=article_inline</a:t>
            </a:r>
            <a:endParaRPr lang="en-US" sz="900" dirty="0"/>
          </a:p>
          <a:p>
            <a:r>
              <a:rPr lang="en-US" sz="900" dirty="0">
                <a:hlinkClick r:id="rId6"/>
              </a:rPr>
              <a:t>https://www.wsj.com/articles/as-covid-19-surges-the-big-unknown-is-where-people-are-getting-infected-11605474874</a:t>
            </a:r>
            <a:r>
              <a:rPr lang="en-US" sz="900" dirty="0"/>
              <a:t>  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D703399-C42A-4341-BEA0-3D81959027A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9770" y="1004887"/>
            <a:ext cx="7267194" cy="4017074"/>
          </a:xfrm>
          <a:prstGeom prst="rect">
            <a:avLst/>
          </a:prstGeom>
        </p:spPr>
      </p:pic>
      <p:sp>
        <p:nvSpPr>
          <p:cNvPr id="11" name="Arrow: Right 10">
            <a:extLst>
              <a:ext uri="{FF2B5EF4-FFF2-40B4-BE49-F238E27FC236}">
                <a16:creationId xmlns:a16="http://schemas.microsoft.com/office/drawing/2014/main" id="{08D0E26F-EAB1-4720-9CE4-22CA66D968CF}"/>
              </a:ext>
            </a:extLst>
          </p:cNvPr>
          <p:cNvSpPr/>
          <p:nvPr/>
        </p:nvSpPr>
        <p:spPr>
          <a:xfrm rot="5400000">
            <a:off x="5244439" y="4271499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8434389" y="1673309"/>
            <a:ext cx="457200" cy="180975"/>
          </a:xfrm>
          <a:prstGeom prst="rightArrow">
            <a:avLst/>
          </a:prstGeom>
          <a:solidFill>
            <a:schemeClr val="bg1">
              <a:lumMod val="65000"/>
              <a:alpha val="40000"/>
            </a:schemeClr>
          </a:solidFill>
          <a:ln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314E1A1-CE30-4AD2-86E9-6A38A24AE9F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362023" y="752475"/>
            <a:ext cx="5381625" cy="5353050"/>
          </a:xfrm>
          <a:prstGeom prst="rect">
            <a:avLst/>
          </a:prstGeom>
        </p:spPr>
      </p:pic>
      <p:sp>
        <p:nvSpPr>
          <p:cNvPr id="14" name="Arrow: Right 13">
            <a:extLst>
              <a:ext uri="{FF2B5EF4-FFF2-40B4-BE49-F238E27FC236}">
                <a16:creationId xmlns:a16="http://schemas.microsoft.com/office/drawing/2014/main" id="{3281CB37-AF75-4B18-ACCD-D2389703AE78}"/>
              </a:ext>
            </a:extLst>
          </p:cNvPr>
          <p:cNvSpPr/>
          <p:nvPr/>
        </p:nvSpPr>
        <p:spPr>
          <a:xfrm rot="5400000">
            <a:off x="3826003" y="4200696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470B5A1-4645-421C-B403-1F9023AC038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3398975-40CB-4FFA-9C16-7AA102056CDB}"/>
              </a:ext>
            </a:extLst>
          </p:cNvPr>
          <p:cNvSpPr txBox="1"/>
          <p:nvPr/>
        </p:nvSpPr>
        <p:spPr>
          <a:xfrm>
            <a:off x="2689927" y="97526"/>
            <a:ext cx="399256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have remained open in France since Jun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In 40-75% of cases, the source of the infection is unknown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299AC65B-DC1A-45A3-B887-A300405271E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1662735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German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803301" cy="1579479"/>
          </a:xfrm>
        </p:spPr>
        <p:txBody>
          <a:bodyPr>
            <a:normAutofit/>
          </a:bodyPr>
          <a:lstStyle/>
          <a:p>
            <a:r>
              <a:rPr lang="en-US" sz="1600" dirty="0"/>
              <a:t>School closing: 3/13</a:t>
            </a:r>
          </a:p>
          <a:p>
            <a:r>
              <a:rPr lang="en-US" sz="1600" dirty="0"/>
              <a:t>School reopening: ~8/5</a:t>
            </a:r>
          </a:p>
          <a:p>
            <a:r>
              <a:rPr lang="en-US" sz="1600" dirty="0"/>
              <a:t>Second lockdown: 10/30 (schools remain open)</a:t>
            </a:r>
          </a:p>
          <a:p>
            <a:r>
              <a:rPr lang="en-US" sz="1600" dirty="0"/>
              <a:t>School closing: 12/13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363360" y="5906107"/>
            <a:ext cx="777098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2"/>
              </a:rPr>
              <a:t>https://en.wikipedia.org/wiki/COVID-19_pandemic_in_Germany</a:t>
            </a:r>
            <a:endParaRPr lang="en-US" sz="900" dirty="0"/>
          </a:p>
          <a:p>
            <a:r>
              <a:rPr lang="en-US" sz="900" dirty="0">
                <a:hlinkClick r:id="rId3"/>
              </a:rPr>
              <a:t>https://fortune.com/2020/08/10/covid-schools-reopening-class-children-coronavirus/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4"/>
              </a:rPr>
              <a:t>https://www.theguardian.com/world/2020/dec/13/germany-to-close-shops-and-schools-in-tightened-covid-lockdown</a:t>
            </a:r>
            <a:endParaRPr lang="en-US" sz="900" dirty="0"/>
          </a:p>
          <a:p>
            <a:r>
              <a:rPr lang="en-US" sz="900" dirty="0">
                <a:hlinkClick r:id="rId5"/>
              </a:rPr>
              <a:t>https://www.wsj.com/articles/contact-tracing-the-wests-big-hope-for-suppressing-covid-19-is-in-disarray-11600337670?mod=article_inline</a:t>
            </a:r>
            <a:endParaRPr lang="en-US" sz="900" dirty="0"/>
          </a:p>
          <a:p>
            <a:r>
              <a:rPr lang="en-US" sz="900" dirty="0">
                <a:hlinkClick r:id="rId6"/>
              </a:rPr>
              <a:t>https://www.wsj.com/articles/as-covid-19-surges-the-big-unknown-is-where-people-are-getting-infected-11605474874</a:t>
            </a:r>
            <a:r>
              <a:rPr lang="en-US" sz="900" dirty="0"/>
              <a:t>   </a:t>
            </a:r>
          </a:p>
          <a:p>
            <a:r>
              <a:rPr lang="en-US" sz="900" dirty="0"/>
              <a:t>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D9DDB3A-98D6-4B93-9AB0-E2AD2A473DB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99770" y="960928"/>
            <a:ext cx="7059740" cy="4023360"/>
          </a:xfrm>
          <a:prstGeom prst="rect">
            <a:avLst/>
          </a:prstGeom>
        </p:spPr>
      </p:pic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9329739" y="899016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4D6882B5-846F-4BCF-87B2-B4BD8A3BA760}"/>
              </a:ext>
            </a:extLst>
          </p:cNvPr>
          <p:cNvSpPr/>
          <p:nvPr/>
        </p:nvSpPr>
        <p:spPr>
          <a:xfrm rot="5400000">
            <a:off x="3709989" y="4210683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" name="Arrow: Right 5">
            <a:extLst>
              <a:ext uri="{FF2B5EF4-FFF2-40B4-BE49-F238E27FC236}">
                <a16:creationId xmlns:a16="http://schemas.microsoft.com/office/drawing/2014/main" id="{2EFDAE88-598A-4733-B636-C76C74DB5879}"/>
              </a:ext>
            </a:extLst>
          </p:cNvPr>
          <p:cNvSpPr/>
          <p:nvPr/>
        </p:nvSpPr>
        <p:spPr>
          <a:xfrm rot="5400000">
            <a:off x="6581977" y="4191633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id="{EC083BC4-4B96-47DC-92A5-84EE0CD41CD6}"/>
              </a:ext>
            </a:extLst>
          </p:cNvPr>
          <p:cNvSpPr/>
          <p:nvPr/>
        </p:nvSpPr>
        <p:spPr>
          <a:xfrm rot="5400000">
            <a:off x="8358189" y="2415423"/>
            <a:ext cx="457200" cy="180975"/>
          </a:xfrm>
          <a:prstGeom prst="rightArrow">
            <a:avLst/>
          </a:prstGeom>
          <a:solidFill>
            <a:schemeClr val="bg1">
              <a:lumMod val="65000"/>
              <a:alpha val="40000"/>
            </a:schemeClr>
          </a:solidFill>
          <a:ln>
            <a:solidFill>
              <a:schemeClr val="bg2">
                <a:lumMod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5318E15-826F-45A9-9B6B-639AE8BD5719}"/>
              </a:ext>
            </a:extLst>
          </p:cNvPr>
          <p:cNvSpPr txBox="1"/>
          <p:nvPr/>
        </p:nvSpPr>
        <p:spPr>
          <a:xfrm>
            <a:off x="2689927" y="114572"/>
            <a:ext cx="6263573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in early August, followed by a wave of infection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Germany entered a stringent lockdown at the end of October, which failed to control spread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closed 12/13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Inset shows France (schools reopened in June) vs Germany (schools reopened in August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In ~75% of the cases, the source of the infection is unknown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16B46700-0968-46F9-9141-21F1AC3F8DE9}"/>
              </a:ext>
            </a:extLst>
          </p:cNvPr>
          <p:cNvGrpSpPr/>
          <p:nvPr/>
        </p:nvGrpSpPr>
        <p:grpSpPr>
          <a:xfrm>
            <a:off x="371475" y="3847636"/>
            <a:ext cx="2546441" cy="1393889"/>
            <a:chOff x="371475" y="3847636"/>
            <a:chExt cx="2546441" cy="139388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E4835DBB-0DCE-4ACD-A4B4-CB04289866B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1475" y="3847636"/>
              <a:ext cx="2546441" cy="13938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8C0ACAD-7B42-44CA-A059-802B3BD80532}"/>
                </a:ext>
              </a:extLst>
            </p:cNvPr>
            <p:cNvSpPr txBox="1"/>
            <p:nvPr/>
          </p:nvSpPr>
          <p:spPr>
            <a:xfrm>
              <a:off x="1715582" y="4005121"/>
              <a:ext cx="6015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8080"/>
                  </a:solidFill>
                </a:rPr>
                <a:t>Franc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CE820FB-039D-45FD-B260-813431F7F253}"/>
                </a:ext>
              </a:extLst>
            </p:cNvPr>
            <p:cNvSpPr txBox="1"/>
            <p:nvPr/>
          </p:nvSpPr>
          <p:spPr>
            <a:xfrm>
              <a:off x="2161472" y="4875936"/>
              <a:ext cx="7556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516176"/>
                  </a:solidFill>
                </a:rPr>
                <a:t>Germany</a:t>
              </a:r>
            </a:p>
          </p:txBody>
        </p:sp>
        <p:sp>
          <p:nvSpPr>
            <p:cNvPr id="16" name="Arrow: Right 15">
              <a:extLst>
                <a:ext uri="{FF2B5EF4-FFF2-40B4-BE49-F238E27FC236}">
                  <a16:creationId xmlns:a16="http://schemas.microsoft.com/office/drawing/2014/main" id="{6F45D8F5-9332-4490-B967-10B1A88FBA05}"/>
                </a:ext>
              </a:extLst>
            </p:cNvPr>
            <p:cNvSpPr/>
            <p:nvPr/>
          </p:nvSpPr>
          <p:spPr>
            <a:xfrm rot="5400000">
              <a:off x="1134932" y="5046795"/>
              <a:ext cx="133258" cy="79023"/>
            </a:xfrm>
            <a:prstGeom prst="rightArrow">
              <a:avLst/>
            </a:prstGeom>
            <a:solidFill>
              <a:srgbClr val="008080">
                <a:alpha val="40000"/>
              </a:srgbClr>
            </a:solidFill>
            <a:ln>
              <a:solidFill>
                <a:srgbClr val="00808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Arrow: Right 16">
              <a:extLst>
                <a:ext uri="{FF2B5EF4-FFF2-40B4-BE49-F238E27FC236}">
                  <a16:creationId xmlns:a16="http://schemas.microsoft.com/office/drawing/2014/main" id="{4BF91B53-DB9E-41E9-89E9-36DBF8E1757D}"/>
                </a:ext>
              </a:extLst>
            </p:cNvPr>
            <p:cNvSpPr/>
            <p:nvPr/>
          </p:nvSpPr>
          <p:spPr>
            <a:xfrm rot="5400000">
              <a:off x="1511281" y="5043156"/>
              <a:ext cx="133258" cy="79023"/>
            </a:xfrm>
            <a:prstGeom prst="rightArrow">
              <a:avLst/>
            </a:prstGeom>
            <a:solidFill>
              <a:srgbClr val="516176">
                <a:alpha val="40000"/>
              </a:srgbClr>
            </a:solidFill>
            <a:ln>
              <a:solidFill>
                <a:srgbClr val="51617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EADAA004-AA81-47CE-918E-BB386EC491E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9659582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4F2702F6-E22F-4596-AC8C-B251084C539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32656" y="1356201"/>
            <a:ext cx="6511671" cy="3726466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F1062AEA-B228-4184-8BC1-73D8CE327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1327"/>
            <a:ext cx="2689927" cy="929601"/>
          </a:xfrm>
        </p:spPr>
        <p:txBody>
          <a:bodyPr>
            <a:normAutofit/>
          </a:bodyPr>
          <a:lstStyle/>
          <a:p>
            <a:pPr algn="ctr"/>
            <a:r>
              <a:rPr lang="en-US" sz="4000" dirty="0"/>
              <a:t>UK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EFA604-BC8A-405F-90D2-EC67B1CF9F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449" y="1716171"/>
            <a:ext cx="2803301" cy="1579479"/>
          </a:xfrm>
        </p:spPr>
        <p:txBody>
          <a:bodyPr>
            <a:noAutofit/>
          </a:bodyPr>
          <a:lstStyle/>
          <a:p>
            <a:r>
              <a:rPr lang="en-US" sz="1600" dirty="0"/>
              <a:t>School closing: 3/23</a:t>
            </a:r>
          </a:p>
          <a:p>
            <a:r>
              <a:rPr lang="en-US" sz="1600" dirty="0"/>
              <a:t>School reopening: ~6/1 (reduced attendance)</a:t>
            </a:r>
          </a:p>
          <a:p>
            <a:r>
              <a:rPr lang="en-US" sz="1600" dirty="0"/>
              <a:t>School closing: 7/20 (summer holiday)</a:t>
            </a:r>
          </a:p>
          <a:p>
            <a:r>
              <a:rPr lang="en-US" sz="1600" dirty="0"/>
              <a:t>School reopening (~9/1)</a:t>
            </a:r>
          </a:p>
          <a:p>
            <a:r>
              <a:rPr lang="en-US" sz="1600" dirty="0"/>
              <a:t>School closing: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2C619F0D-85D3-4883-B171-4AD090B7A463}"/>
              </a:ext>
            </a:extLst>
          </p:cNvPr>
          <p:cNvSpPr/>
          <p:nvPr/>
        </p:nvSpPr>
        <p:spPr>
          <a:xfrm>
            <a:off x="363360" y="5906107"/>
            <a:ext cx="77709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hlinkClick r:id="rId3"/>
              </a:rPr>
              <a:t>https://www.cidrap.umn.edu/news-perspective/2020/12/few-cases-or-outbreaks-uk-schools-reopened-after-lockdown</a:t>
            </a:r>
            <a:endParaRPr lang="en-US" sz="900" dirty="0"/>
          </a:p>
          <a:p>
            <a:r>
              <a:rPr lang="en-US" sz="900" dirty="0">
                <a:hlinkClick r:id="rId4"/>
              </a:rPr>
              <a:t>https://www.nytimes.com/2020/08/29/world/europe/britain-schools-reopen-cornavirus.html</a:t>
            </a:r>
            <a:r>
              <a:rPr lang="en-US" sz="900" dirty="0"/>
              <a:t> </a:t>
            </a:r>
          </a:p>
          <a:p>
            <a:r>
              <a:rPr lang="en-US" sz="900" dirty="0">
                <a:hlinkClick r:id="rId5"/>
              </a:rPr>
              <a:t>https://www.telegraph.co.uk/news/2021/01/11/schools-closed-new-lockdown-when-reopen-uk-areas-covid/</a:t>
            </a:r>
            <a:r>
              <a:rPr lang="en-US" sz="900" dirty="0"/>
              <a:t> </a:t>
            </a:r>
          </a:p>
          <a:p>
            <a:r>
              <a:rPr lang="en-US" sz="900" dirty="0"/>
              <a:t>  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FF42C1FE-E9AB-4E4A-826F-34E98263A04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93104"/>
          <a:stretch/>
        </p:blipFill>
        <p:spPr>
          <a:xfrm>
            <a:off x="3332656" y="5110826"/>
            <a:ext cx="7374944" cy="320166"/>
          </a:xfrm>
          <a:prstGeom prst="rect">
            <a:avLst/>
          </a:prstGeom>
        </p:spPr>
      </p:pic>
      <p:sp>
        <p:nvSpPr>
          <p:cNvPr id="10" name="Arrow: Right 9">
            <a:extLst>
              <a:ext uri="{FF2B5EF4-FFF2-40B4-BE49-F238E27FC236}">
                <a16:creationId xmlns:a16="http://schemas.microsoft.com/office/drawing/2014/main" id="{44A7D2F4-098B-4B31-9C34-6D878477A228}"/>
              </a:ext>
            </a:extLst>
          </p:cNvPr>
          <p:cNvSpPr/>
          <p:nvPr/>
        </p:nvSpPr>
        <p:spPr>
          <a:xfrm rot="5400000">
            <a:off x="4249067" y="4207012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4D6882B5-846F-4BCF-87B2-B4BD8A3BA760}"/>
              </a:ext>
            </a:extLst>
          </p:cNvPr>
          <p:cNvSpPr/>
          <p:nvPr/>
        </p:nvSpPr>
        <p:spPr>
          <a:xfrm rot="5400000">
            <a:off x="6121514" y="4281792"/>
            <a:ext cx="457200" cy="180975"/>
          </a:xfrm>
          <a:prstGeom prst="rightArrow">
            <a:avLst/>
          </a:prstGeom>
          <a:solidFill>
            <a:srgbClr val="FF3B3B">
              <a:alpha val="40000"/>
            </a:srgbClr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5318E15-826F-45A9-9B6B-639AE8BD5719}"/>
              </a:ext>
            </a:extLst>
          </p:cNvPr>
          <p:cNvSpPr txBox="1"/>
          <p:nvPr/>
        </p:nvSpPr>
        <p:spPr>
          <a:xfrm>
            <a:off x="2689927" y="171703"/>
            <a:ext cx="626357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at the beginning of June for a reduced-attendance summer half-term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reopened in the fall at the beginning of September, followed by a sharp rise in cas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/>
              <a:t>Schools were closed again at the beginning of January</a:t>
            </a:r>
          </a:p>
        </p:txBody>
      </p:sp>
      <p:sp>
        <p:nvSpPr>
          <p:cNvPr id="19" name="Arrow: Right 18">
            <a:extLst>
              <a:ext uri="{FF2B5EF4-FFF2-40B4-BE49-F238E27FC236}">
                <a16:creationId xmlns:a16="http://schemas.microsoft.com/office/drawing/2014/main" id="{05B024D8-23C3-41BE-B34A-FC3E0A84F36C}"/>
              </a:ext>
            </a:extLst>
          </p:cNvPr>
          <p:cNvSpPr/>
          <p:nvPr/>
        </p:nvSpPr>
        <p:spPr>
          <a:xfrm rot="5400000">
            <a:off x="5283136" y="4225412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Arrow: Right 19">
            <a:extLst>
              <a:ext uri="{FF2B5EF4-FFF2-40B4-BE49-F238E27FC236}">
                <a16:creationId xmlns:a16="http://schemas.microsoft.com/office/drawing/2014/main" id="{6AC611CE-C3BD-48EE-A09D-7E44D900512C}"/>
              </a:ext>
            </a:extLst>
          </p:cNvPr>
          <p:cNvSpPr/>
          <p:nvPr/>
        </p:nvSpPr>
        <p:spPr>
          <a:xfrm rot="5400000">
            <a:off x="6785041" y="4225413"/>
            <a:ext cx="457200" cy="180975"/>
          </a:xfrm>
          <a:prstGeom prst="rightArrow">
            <a:avLst/>
          </a:prstGeom>
          <a:solidFill>
            <a:srgbClr val="4472C4">
              <a:alpha val="40000"/>
            </a:srgb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AA87E683-8139-4AA7-958E-F632EBE825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365118" y="3319633"/>
            <a:ext cx="1710191" cy="1667339"/>
          </a:xfrm>
          <a:prstGeom prst="rect">
            <a:avLst/>
          </a:prstGeom>
          <a:ln>
            <a:solidFill>
              <a:schemeClr val="bg2">
                <a:lumMod val="25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8671155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82</TotalTime>
  <Words>2184</Words>
  <Application>Microsoft Office PowerPoint</Application>
  <PresentationFormat>Widescreen</PresentationFormat>
  <Paragraphs>228</Paragraphs>
  <Slides>2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6" baseType="lpstr">
      <vt:lpstr>Arial</vt:lpstr>
      <vt:lpstr>Calibri</vt:lpstr>
      <vt:lpstr>Calibri Light</vt:lpstr>
      <vt:lpstr>Office Theme</vt:lpstr>
      <vt:lpstr>Timing of school opening and closing vs COVID case counts</vt:lpstr>
      <vt:lpstr>Methodology </vt:lpstr>
      <vt:lpstr>Israel</vt:lpstr>
      <vt:lpstr>Pakistan</vt:lpstr>
      <vt:lpstr>India</vt:lpstr>
      <vt:lpstr>Sweden</vt:lpstr>
      <vt:lpstr>France</vt:lpstr>
      <vt:lpstr>Germany</vt:lpstr>
      <vt:lpstr>UK</vt:lpstr>
      <vt:lpstr>Netherlands</vt:lpstr>
      <vt:lpstr>Denmark</vt:lpstr>
      <vt:lpstr>Spain</vt:lpstr>
      <vt:lpstr>Ireland</vt:lpstr>
      <vt:lpstr>Portugal</vt:lpstr>
      <vt:lpstr>Belgium</vt:lpstr>
      <vt:lpstr>Italy</vt:lpstr>
      <vt:lpstr>Czechia</vt:lpstr>
      <vt:lpstr>Taiwan</vt:lpstr>
      <vt:lpstr>Japan</vt:lpstr>
      <vt:lpstr>South Korea</vt:lpstr>
      <vt:lpstr>Canada</vt:lpstr>
      <vt:lpstr>U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ch</dc:creator>
  <cp:lastModifiedBy>ach</cp:lastModifiedBy>
  <cp:revision>38</cp:revision>
  <dcterms:created xsi:type="dcterms:W3CDTF">2021-01-12T01:50:36Z</dcterms:created>
  <dcterms:modified xsi:type="dcterms:W3CDTF">2021-01-24T17:14:27Z</dcterms:modified>
</cp:coreProperties>
</file>